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  <p:sldId id="257" r:id="rId3"/>
    <p:sldId id="263" r:id="rId4"/>
    <p:sldId id="264" r:id="rId5"/>
    <p:sldId id="265" r:id="rId6"/>
    <p:sldId id="260" r:id="rId7"/>
  </p:sldIdLst>
  <p:sldSz cx="16256000" cy="9144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0846" autoAdjust="0"/>
    <p:restoredTop sz="94660"/>
  </p:normalViewPr>
  <p:slideViewPr>
    <p:cSldViewPr snapToGrid="0">
      <p:cViewPr varScale="1">
        <p:scale>
          <a:sx n="72" d="100"/>
          <a:sy n="72" d="100"/>
        </p:scale>
        <p:origin x="374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032000" y="1496484"/>
            <a:ext cx="12192000" cy="3183467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032000" y="4802717"/>
            <a:ext cx="12192000" cy="2207683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FFF80-9AA7-41E6-93F4-7ABBC240E6B8}" type="datetimeFigureOut">
              <a:rPr kumimoji="1" lang="ja-JP" altLang="en-US" smtClean="0"/>
              <a:t>2023/9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874FD3-F43B-4BE0-A612-A87628FCE62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395668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FFF80-9AA7-41E6-93F4-7ABBC240E6B8}" type="datetimeFigureOut">
              <a:rPr kumimoji="1" lang="ja-JP" altLang="en-US" smtClean="0"/>
              <a:t>2023/9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874FD3-F43B-4BE0-A612-A87628FCE62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516093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1633200" y="486834"/>
            <a:ext cx="3505200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117600" y="486834"/>
            <a:ext cx="10312400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FFF80-9AA7-41E6-93F4-7ABBC240E6B8}" type="datetimeFigureOut">
              <a:rPr kumimoji="1" lang="ja-JP" altLang="en-US" smtClean="0"/>
              <a:t>2023/9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874FD3-F43B-4BE0-A612-A87628FCE62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83790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FFF80-9AA7-41E6-93F4-7ABBC240E6B8}" type="datetimeFigureOut">
              <a:rPr kumimoji="1" lang="ja-JP" altLang="en-US" smtClean="0"/>
              <a:t>2023/9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874FD3-F43B-4BE0-A612-A87628FCE62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256371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09133" y="2279652"/>
            <a:ext cx="14020800" cy="3803649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09133" y="6119285"/>
            <a:ext cx="14020800" cy="200024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FFF80-9AA7-41E6-93F4-7ABBC240E6B8}" type="datetimeFigureOut">
              <a:rPr kumimoji="1" lang="ja-JP" altLang="en-US" smtClean="0"/>
              <a:t>2023/9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874FD3-F43B-4BE0-A612-A87628FCE62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067977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117600" y="2434167"/>
            <a:ext cx="690880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229600" y="2434167"/>
            <a:ext cx="690880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FFF80-9AA7-41E6-93F4-7ABBC240E6B8}" type="datetimeFigureOut">
              <a:rPr kumimoji="1" lang="ja-JP" altLang="en-US" smtClean="0"/>
              <a:t>2023/9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874FD3-F43B-4BE0-A612-A87628FCE62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045133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9717" y="486834"/>
            <a:ext cx="14020800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9718" y="2241551"/>
            <a:ext cx="6877049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119718" y="3340100"/>
            <a:ext cx="6877049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8229600" y="2241551"/>
            <a:ext cx="6910917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8229600" y="3340100"/>
            <a:ext cx="6910917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FFF80-9AA7-41E6-93F4-7ABBC240E6B8}" type="datetimeFigureOut">
              <a:rPr kumimoji="1" lang="ja-JP" altLang="en-US" smtClean="0"/>
              <a:t>2023/9/2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874FD3-F43B-4BE0-A612-A87628FCE62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117077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FFF80-9AA7-41E6-93F4-7ABBC240E6B8}" type="datetimeFigureOut">
              <a:rPr kumimoji="1" lang="ja-JP" altLang="en-US" smtClean="0"/>
              <a:t>2023/9/2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874FD3-F43B-4BE0-A612-A87628FCE62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308752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FFF80-9AA7-41E6-93F4-7ABBC240E6B8}" type="datetimeFigureOut">
              <a:rPr kumimoji="1" lang="ja-JP" altLang="en-US" smtClean="0"/>
              <a:t>2023/9/2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874FD3-F43B-4BE0-A612-A87628FCE62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242211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9718" y="609600"/>
            <a:ext cx="5242983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910917" y="1316567"/>
            <a:ext cx="8229600" cy="6498167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19718" y="2743200"/>
            <a:ext cx="5242983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FFF80-9AA7-41E6-93F4-7ABBC240E6B8}" type="datetimeFigureOut">
              <a:rPr kumimoji="1" lang="ja-JP" altLang="en-US" smtClean="0"/>
              <a:t>2023/9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874FD3-F43B-4BE0-A612-A87628FCE62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53033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9718" y="609600"/>
            <a:ext cx="5242983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910917" y="1316567"/>
            <a:ext cx="8229600" cy="6498167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19718" y="2743200"/>
            <a:ext cx="5242983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FFF80-9AA7-41E6-93F4-7ABBC240E6B8}" type="datetimeFigureOut">
              <a:rPr kumimoji="1" lang="ja-JP" altLang="en-US" smtClean="0"/>
              <a:t>2023/9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874FD3-F43B-4BE0-A612-A87628FCE62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023623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17600" y="486834"/>
            <a:ext cx="14020800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7600" y="2434167"/>
            <a:ext cx="14020800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117600" y="8475134"/>
            <a:ext cx="36576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EFFF80-9AA7-41E6-93F4-7ABBC240E6B8}" type="datetimeFigureOut">
              <a:rPr kumimoji="1" lang="ja-JP" altLang="en-US" smtClean="0"/>
              <a:t>2023/9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384800" y="8475134"/>
            <a:ext cx="54864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1480800" y="8475134"/>
            <a:ext cx="36576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874FD3-F43B-4BE0-A612-A87628FCE62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792785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kumimoji="1"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kumimoji="1"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7" Type="http://schemas.openxmlformats.org/officeDocument/2006/relationships/image" Target="../media/image9.jpeg"/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.jpeg"/><Relationship Id="rId5" Type="http://schemas.openxmlformats.org/officeDocument/2006/relationships/image" Target="../media/image7.jpeg"/><Relationship Id="rId4" Type="http://schemas.openxmlformats.org/officeDocument/2006/relationships/image" Target="../media/image6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jpeg"/><Relationship Id="rId7" Type="http://schemas.openxmlformats.org/officeDocument/2006/relationships/image" Target="../media/image15.jpeg"/><Relationship Id="rId2" Type="http://schemas.openxmlformats.org/officeDocument/2006/relationships/image" Target="../media/image10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4.jpeg"/><Relationship Id="rId5" Type="http://schemas.openxmlformats.org/officeDocument/2006/relationships/image" Target="../media/image13.jpeg"/><Relationship Id="rId4" Type="http://schemas.openxmlformats.org/officeDocument/2006/relationships/image" Target="../media/image12.jpe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8.png"/><Relationship Id="rId4" Type="http://schemas.openxmlformats.org/officeDocument/2006/relationships/image" Target="../media/image17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.bin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0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319273" y="203248"/>
            <a:ext cx="129715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ja-JP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S1</a:t>
            </a:r>
            <a:endParaRPr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2811721" y="8209049"/>
            <a:ext cx="1063255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1. 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Levels of M2 macrophage signature (</a:t>
            </a:r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) and TGF</a:t>
            </a:r>
            <a:r>
              <a:rPr lang="el-GR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-stromal signature (TBSS) (</a:t>
            </a:r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) in association with </a:t>
            </a:r>
            <a:r>
              <a:rPr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TGFB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in MSI and MSS CRCs in TCGA dataset. **** </a:t>
            </a:r>
            <a:r>
              <a:rPr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&lt; 0.0001, </a:t>
            </a:r>
            <a:r>
              <a:rPr lang="en-US" altLang="ja-JP" sz="1400" i="1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r>
              <a:rPr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&gt; 0.05.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" name="オブジェクト 1">
            <a:extLst>
              <a:ext uri="{FF2B5EF4-FFF2-40B4-BE49-F238E27FC236}">
                <a16:creationId xmlns:a16="http://schemas.microsoft.com/office/drawing/2014/main" id="{478AD5FF-2803-B8EF-8373-B5D2BCFDB95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14575942"/>
              </p:ext>
            </p:extLst>
          </p:nvPr>
        </p:nvGraphicFramePr>
        <p:xfrm>
          <a:off x="3214688" y="741363"/>
          <a:ext cx="9826625" cy="71151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6485296" imgH="4699659" progId="Prism9.Document">
                  <p:embed/>
                </p:oleObj>
              </mc:Choice>
              <mc:Fallback>
                <p:oleObj name="Prism 9" r:id="rId2" imgW="6485296" imgH="4699659" progId="Prism9.Document">
                  <p:embed/>
                  <p:pic>
                    <p:nvPicPr>
                      <p:cNvPr id="2" name="オブジェクト 1">
                        <a:extLst>
                          <a:ext uri="{FF2B5EF4-FFF2-40B4-BE49-F238E27FC236}">
                            <a16:creationId xmlns:a16="http://schemas.microsoft.com/office/drawing/2014/main" id="{DFA34805-4C70-BD4B-5971-CA1A5F5D72E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214688" y="741363"/>
                        <a:ext cx="9826625" cy="71151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86830574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373205" y="233345"/>
            <a:ext cx="129715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ja-JP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S2</a:t>
            </a:r>
            <a:endParaRPr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3"/>
          <p:cNvSpPr txBox="1"/>
          <p:nvPr/>
        </p:nvSpPr>
        <p:spPr>
          <a:xfrm>
            <a:off x="4288926" y="7348892"/>
            <a:ext cx="7320481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2. 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airwise correlations between the expression of </a:t>
            </a:r>
            <a:r>
              <a:rPr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TGFB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, TGF</a:t>
            </a:r>
            <a:r>
              <a:rPr lang="el-GR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-stromal signature (TBSS), M2 macrophage signature and </a:t>
            </a:r>
            <a:r>
              <a:rPr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HAVCR2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, in six independent cohorts of CRC. Numbers in plot indicate Spearman’s coefficients. </a:t>
            </a:r>
            <a:r>
              <a:rPr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-values for all correlations &lt; 0.0001.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図 5">
            <a:extLst>
              <a:ext uri="{FF2B5EF4-FFF2-40B4-BE49-F238E27FC236}">
                <a16:creationId xmlns:a16="http://schemas.microsoft.com/office/drawing/2014/main" id="{6493E2AC-3767-05F1-DCB4-D479D5A949A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94197" y="1266097"/>
            <a:ext cx="8986889" cy="5028378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58B5B757-189F-CCCD-E126-2B238FF1F41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677525" y="5468537"/>
            <a:ext cx="2718277" cy="8259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160159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D8A85338-3CBF-990B-86E0-4880C194284A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94382" y="780357"/>
            <a:ext cx="4534452" cy="256952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7" name="図 16">
            <a:extLst>
              <a:ext uri="{FF2B5EF4-FFF2-40B4-BE49-F238E27FC236}">
                <a16:creationId xmlns:a16="http://schemas.microsoft.com/office/drawing/2014/main" id="{09A30417-BD77-6D56-FFB1-135542E0DADA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55961" y="780357"/>
            <a:ext cx="4534452" cy="256952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9" name="図 28">
            <a:extLst>
              <a:ext uri="{FF2B5EF4-FFF2-40B4-BE49-F238E27FC236}">
                <a16:creationId xmlns:a16="http://schemas.microsoft.com/office/drawing/2014/main" id="{C1FEDA26-3B47-F4A7-0741-CA80C5AC754C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94382" y="6325643"/>
            <a:ext cx="4534452" cy="256952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1" name="図 30">
            <a:extLst>
              <a:ext uri="{FF2B5EF4-FFF2-40B4-BE49-F238E27FC236}">
                <a16:creationId xmlns:a16="http://schemas.microsoft.com/office/drawing/2014/main" id="{0A16181E-11A4-A00A-EC2E-17C8E3E1987A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526"/>
          <a:stretch/>
        </p:blipFill>
        <p:spPr>
          <a:xfrm>
            <a:off x="2155961" y="6345429"/>
            <a:ext cx="4534452" cy="256952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" name="正方形/長方形 2">
            <a:extLst>
              <a:ext uri="{FF2B5EF4-FFF2-40B4-BE49-F238E27FC236}">
                <a16:creationId xmlns:a16="http://schemas.microsoft.com/office/drawing/2014/main" id="{EB091716-C055-A47A-F6BC-461D88894DCA}"/>
              </a:ext>
            </a:extLst>
          </p:cNvPr>
          <p:cNvSpPr/>
          <p:nvPr/>
        </p:nvSpPr>
        <p:spPr>
          <a:xfrm>
            <a:off x="3749309" y="2091845"/>
            <a:ext cx="654422" cy="37083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" name="正方形/長方形 5">
            <a:extLst>
              <a:ext uri="{FF2B5EF4-FFF2-40B4-BE49-F238E27FC236}">
                <a16:creationId xmlns:a16="http://schemas.microsoft.com/office/drawing/2014/main" id="{EBF69157-78D4-112C-559E-12C7C5CB40B2}"/>
              </a:ext>
            </a:extLst>
          </p:cNvPr>
          <p:cNvSpPr/>
          <p:nvPr/>
        </p:nvSpPr>
        <p:spPr>
          <a:xfrm>
            <a:off x="5321947" y="7366618"/>
            <a:ext cx="654422" cy="37083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pic>
        <p:nvPicPr>
          <p:cNvPr id="14" name="図 13">
            <a:extLst>
              <a:ext uri="{FF2B5EF4-FFF2-40B4-BE49-F238E27FC236}">
                <a16:creationId xmlns:a16="http://schemas.microsoft.com/office/drawing/2014/main" id="{90B413F1-3FA8-8C02-8662-887A30F62901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557"/>
          <a:stretch/>
        </p:blipFill>
        <p:spPr>
          <a:xfrm>
            <a:off x="2155961" y="3562892"/>
            <a:ext cx="4536000" cy="256952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6" name="図 15">
            <a:extLst>
              <a:ext uri="{FF2B5EF4-FFF2-40B4-BE49-F238E27FC236}">
                <a16:creationId xmlns:a16="http://schemas.microsoft.com/office/drawing/2014/main" id="{2B1047D0-1F33-3295-B75C-BF2C0A204EA1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557"/>
          <a:stretch/>
        </p:blipFill>
        <p:spPr>
          <a:xfrm>
            <a:off x="6894382" y="3562892"/>
            <a:ext cx="4536000" cy="256952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9697D37D-85B3-5FEA-8042-ACC646D6261B}"/>
              </a:ext>
            </a:extLst>
          </p:cNvPr>
          <p:cNvSpPr/>
          <p:nvPr/>
        </p:nvSpPr>
        <p:spPr>
          <a:xfrm>
            <a:off x="3949343" y="5507867"/>
            <a:ext cx="654422" cy="37083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24FC34AB-54CC-86DE-934E-989B9782DF6D}"/>
              </a:ext>
            </a:extLst>
          </p:cNvPr>
          <p:cNvSpPr txBox="1"/>
          <p:nvPr/>
        </p:nvSpPr>
        <p:spPr>
          <a:xfrm>
            <a:off x="319273" y="203248"/>
            <a:ext cx="129715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ja-JP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S3</a:t>
            </a:r>
            <a:endParaRPr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正方形/長方形 21">
            <a:extLst>
              <a:ext uri="{FF2B5EF4-FFF2-40B4-BE49-F238E27FC236}">
                <a16:creationId xmlns:a16="http://schemas.microsoft.com/office/drawing/2014/main" id="{BCE4FAA0-BE02-1F10-5026-BF44FF9FF766}"/>
              </a:ext>
            </a:extLst>
          </p:cNvPr>
          <p:cNvSpPr/>
          <p:nvPr/>
        </p:nvSpPr>
        <p:spPr>
          <a:xfrm>
            <a:off x="4402243" y="776201"/>
            <a:ext cx="2486495" cy="2569523"/>
          </a:xfrm>
          <a:custGeom>
            <a:avLst/>
            <a:gdLst>
              <a:gd name="connsiteX0" fmla="*/ 0 w 2490651"/>
              <a:gd name="connsiteY0" fmla="*/ 0 h 2589310"/>
              <a:gd name="connsiteX1" fmla="*/ 2490651 w 2490651"/>
              <a:gd name="connsiteY1" fmla="*/ 0 h 2589310"/>
              <a:gd name="connsiteX2" fmla="*/ 2490651 w 2490651"/>
              <a:gd name="connsiteY2" fmla="*/ 2589310 h 2589310"/>
              <a:gd name="connsiteX3" fmla="*/ 0 w 2490651"/>
              <a:gd name="connsiteY3" fmla="*/ 2589310 h 2589310"/>
              <a:gd name="connsiteX4" fmla="*/ 0 w 2490651"/>
              <a:gd name="connsiteY4" fmla="*/ 0 h 2589310"/>
              <a:gd name="connsiteX0" fmla="*/ 0 w 2490651"/>
              <a:gd name="connsiteY0" fmla="*/ 0 h 2589310"/>
              <a:gd name="connsiteX1" fmla="*/ 2490651 w 2490651"/>
              <a:gd name="connsiteY1" fmla="*/ 0 h 2589310"/>
              <a:gd name="connsiteX2" fmla="*/ 2490651 w 2490651"/>
              <a:gd name="connsiteY2" fmla="*/ 2589310 h 2589310"/>
              <a:gd name="connsiteX3" fmla="*/ 8313 w 2490651"/>
              <a:gd name="connsiteY3" fmla="*/ 1687379 h 2589310"/>
              <a:gd name="connsiteX4" fmla="*/ 0 w 2490651"/>
              <a:gd name="connsiteY4" fmla="*/ 0 h 2589310"/>
              <a:gd name="connsiteX0" fmla="*/ 0 w 2494807"/>
              <a:gd name="connsiteY0" fmla="*/ 1309254 h 2589310"/>
              <a:gd name="connsiteX1" fmla="*/ 2494807 w 2494807"/>
              <a:gd name="connsiteY1" fmla="*/ 0 h 2589310"/>
              <a:gd name="connsiteX2" fmla="*/ 2494807 w 2494807"/>
              <a:gd name="connsiteY2" fmla="*/ 2589310 h 2589310"/>
              <a:gd name="connsiteX3" fmla="*/ 12469 w 2494807"/>
              <a:gd name="connsiteY3" fmla="*/ 1687379 h 2589310"/>
              <a:gd name="connsiteX4" fmla="*/ 0 w 2494807"/>
              <a:gd name="connsiteY4" fmla="*/ 1309254 h 2589310"/>
              <a:gd name="connsiteX0" fmla="*/ 0 w 2486495"/>
              <a:gd name="connsiteY0" fmla="*/ 1317567 h 2589310"/>
              <a:gd name="connsiteX1" fmla="*/ 2486495 w 2486495"/>
              <a:gd name="connsiteY1" fmla="*/ 0 h 2589310"/>
              <a:gd name="connsiteX2" fmla="*/ 2486495 w 2486495"/>
              <a:gd name="connsiteY2" fmla="*/ 2589310 h 2589310"/>
              <a:gd name="connsiteX3" fmla="*/ 4157 w 2486495"/>
              <a:gd name="connsiteY3" fmla="*/ 1687379 h 2589310"/>
              <a:gd name="connsiteX4" fmla="*/ 0 w 2486495"/>
              <a:gd name="connsiteY4" fmla="*/ 1317567 h 2589310"/>
              <a:gd name="connsiteX0" fmla="*/ 0 w 2486495"/>
              <a:gd name="connsiteY0" fmla="*/ 1328943 h 2589310"/>
              <a:gd name="connsiteX1" fmla="*/ 2486495 w 2486495"/>
              <a:gd name="connsiteY1" fmla="*/ 0 h 2589310"/>
              <a:gd name="connsiteX2" fmla="*/ 2486495 w 2486495"/>
              <a:gd name="connsiteY2" fmla="*/ 2589310 h 2589310"/>
              <a:gd name="connsiteX3" fmla="*/ 4157 w 2486495"/>
              <a:gd name="connsiteY3" fmla="*/ 1687379 h 2589310"/>
              <a:gd name="connsiteX4" fmla="*/ 0 w 2486495"/>
              <a:gd name="connsiteY4" fmla="*/ 1328943 h 2589310"/>
              <a:gd name="connsiteX0" fmla="*/ 0 w 2486495"/>
              <a:gd name="connsiteY0" fmla="*/ 1328943 h 2589310"/>
              <a:gd name="connsiteX1" fmla="*/ 2486495 w 2486495"/>
              <a:gd name="connsiteY1" fmla="*/ 0 h 2589310"/>
              <a:gd name="connsiteX2" fmla="*/ 2486495 w 2486495"/>
              <a:gd name="connsiteY2" fmla="*/ 2589310 h 2589310"/>
              <a:gd name="connsiteX3" fmla="*/ 4157 w 2486495"/>
              <a:gd name="connsiteY3" fmla="*/ 1707287 h 2589310"/>
              <a:gd name="connsiteX4" fmla="*/ 0 w 2486495"/>
              <a:gd name="connsiteY4" fmla="*/ 1328943 h 2589310"/>
              <a:gd name="connsiteX0" fmla="*/ 0 w 2486495"/>
              <a:gd name="connsiteY0" fmla="*/ 1328943 h 2589310"/>
              <a:gd name="connsiteX1" fmla="*/ 2486495 w 2486495"/>
              <a:gd name="connsiteY1" fmla="*/ 0 h 2589310"/>
              <a:gd name="connsiteX2" fmla="*/ 2486495 w 2486495"/>
              <a:gd name="connsiteY2" fmla="*/ 2589310 h 2589310"/>
              <a:gd name="connsiteX3" fmla="*/ 4157 w 2486495"/>
              <a:gd name="connsiteY3" fmla="*/ 1698755 h 2589310"/>
              <a:gd name="connsiteX4" fmla="*/ 0 w 2486495"/>
              <a:gd name="connsiteY4" fmla="*/ 1328943 h 258931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2486495" h="2589310">
                <a:moveTo>
                  <a:pt x="0" y="1328943"/>
                </a:moveTo>
                <a:lnTo>
                  <a:pt x="2486495" y="0"/>
                </a:lnTo>
                <a:lnTo>
                  <a:pt x="2486495" y="2589310"/>
                </a:lnTo>
                <a:lnTo>
                  <a:pt x="4157" y="1698755"/>
                </a:lnTo>
                <a:cubicBezTo>
                  <a:pt x="2771" y="1575484"/>
                  <a:pt x="1386" y="1452214"/>
                  <a:pt x="0" y="1328943"/>
                </a:cubicBez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3" name="正方形/長方形 21">
            <a:extLst>
              <a:ext uri="{FF2B5EF4-FFF2-40B4-BE49-F238E27FC236}">
                <a16:creationId xmlns:a16="http://schemas.microsoft.com/office/drawing/2014/main" id="{8E35E48B-AD2F-7BDE-20AD-BA2373147CB5}"/>
              </a:ext>
            </a:extLst>
          </p:cNvPr>
          <p:cNvSpPr/>
          <p:nvPr/>
        </p:nvSpPr>
        <p:spPr>
          <a:xfrm>
            <a:off x="4600665" y="3563948"/>
            <a:ext cx="2288073" cy="2569523"/>
          </a:xfrm>
          <a:custGeom>
            <a:avLst/>
            <a:gdLst>
              <a:gd name="connsiteX0" fmla="*/ 0 w 2490651"/>
              <a:gd name="connsiteY0" fmla="*/ 0 h 2589310"/>
              <a:gd name="connsiteX1" fmla="*/ 2490651 w 2490651"/>
              <a:gd name="connsiteY1" fmla="*/ 0 h 2589310"/>
              <a:gd name="connsiteX2" fmla="*/ 2490651 w 2490651"/>
              <a:gd name="connsiteY2" fmla="*/ 2589310 h 2589310"/>
              <a:gd name="connsiteX3" fmla="*/ 0 w 2490651"/>
              <a:gd name="connsiteY3" fmla="*/ 2589310 h 2589310"/>
              <a:gd name="connsiteX4" fmla="*/ 0 w 2490651"/>
              <a:gd name="connsiteY4" fmla="*/ 0 h 2589310"/>
              <a:gd name="connsiteX0" fmla="*/ 0 w 2490651"/>
              <a:gd name="connsiteY0" fmla="*/ 0 h 2589310"/>
              <a:gd name="connsiteX1" fmla="*/ 2490651 w 2490651"/>
              <a:gd name="connsiteY1" fmla="*/ 0 h 2589310"/>
              <a:gd name="connsiteX2" fmla="*/ 2490651 w 2490651"/>
              <a:gd name="connsiteY2" fmla="*/ 2589310 h 2589310"/>
              <a:gd name="connsiteX3" fmla="*/ 8313 w 2490651"/>
              <a:gd name="connsiteY3" fmla="*/ 1687379 h 2589310"/>
              <a:gd name="connsiteX4" fmla="*/ 0 w 2490651"/>
              <a:gd name="connsiteY4" fmla="*/ 0 h 2589310"/>
              <a:gd name="connsiteX0" fmla="*/ 0 w 2494807"/>
              <a:gd name="connsiteY0" fmla="*/ 1309254 h 2589310"/>
              <a:gd name="connsiteX1" fmla="*/ 2494807 w 2494807"/>
              <a:gd name="connsiteY1" fmla="*/ 0 h 2589310"/>
              <a:gd name="connsiteX2" fmla="*/ 2494807 w 2494807"/>
              <a:gd name="connsiteY2" fmla="*/ 2589310 h 2589310"/>
              <a:gd name="connsiteX3" fmla="*/ 12469 w 2494807"/>
              <a:gd name="connsiteY3" fmla="*/ 1687379 h 2589310"/>
              <a:gd name="connsiteX4" fmla="*/ 0 w 2494807"/>
              <a:gd name="connsiteY4" fmla="*/ 1309254 h 2589310"/>
              <a:gd name="connsiteX0" fmla="*/ 0 w 2486495"/>
              <a:gd name="connsiteY0" fmla="*/ 1317567 h 2589310"/>
              <a:gd name="connsiteX1" fmla="*/ 2486495 w 2486495"/>
              <a:gd name="connsiteY1" fmla="*/ 0 h 2589310"/>
              <a:gd name="connsiteX2" fmla="*/ 2486495 w 2486495"/>
              <a:gd name="connsiteY2" fmla="*/ 2589310 h 2589310"/>
              <a:gd name="connsiteX3" fmla="*/ 4157 w 2486495"/>
              <a:gd name="connsiteY3" fmla="*/ 1687379 h 2589310"/>
              <a:gd name="connsiteX4" fmla="*/ 0 w 2486495"/>
              <a:gd name="connsiteY4" fmla="*/ 1317567 h 2589310"/>
              <a:gd name="connsiteX0" fmla="*/ 0 w 2486495"/>
              <a:gd name="connsiteY0" fmla="*/ 1328943 h 2589310"/>
              <a:gd name="connsiteX1" fmla="*/ 2486495 w 2486495"/>
              <a:gd name="connsiteY1" fmla="*/ 0 h 2589310"/>
              <a:gd name="connsiteX2" fmla="*/ 2486495 w 2486495"/>
              <a:gd name="connsiteY2" fmla="*/ 2589310 h 2589310"/>
              <a:gd name="connsiteX3" fmla="*/ 4157 w 2486495"/>
              <a:gd name="connsiteY3" fmla="*/ 1687379 h 2589310"/>
              <a:gd name="connsiteX4" fmla="*/ 0 w 2486495"/>
              <a:gd name="connsiteY4" fmla="*/ 1328943 h 2589310"/>
              <a:gd name="connsiteX0" fmla="*/ 0 w 2486495"/>
              <a:gd name="connsiteY0" fmla="*/ 1328943 h 2589310"/>
              <a:gd name="connsiteX1" fmla="*/ 2486495 w 2486495"/>
              <a:gd name="connsiteY1" fmla="*/ 0 h 2589310"/>
              <a:gd name="connsiteX2" fmla="*/ 2486495 w 2486495"/>
              <a:gd name="connsiteY2" fmla="*/ 2589310 h 2589310"/>
              <a:gd name="connsiteX3" fmla="*/ 4157 w 2486495"/>
              <a:gd name="connsiteY3" fmla="*/ 1707287 h 2589310"/>
              <a:gd name="connsiteX4" fmla="*/ 0 w 2486495"/>
              <a:gd name="connsiteY4" fmla="*/ 1328943 h 2589310"/>
              <a:gd name="connsiteX0" fmla="*/ 0 w 2486495"/>
              <a:gd name="connsiteY0" fmla="*/ 1328943 h 2589310"/>
              <a:gd name="connsiteX1" fmla="*/ 2486495 w 2486495"/>
              <a:gd name="connsiteY1" fmla="*/ 0 h 2589310"/>
              <a:gd name="connsiteX2" fmla="*/ 2486495 w 2486495"/>
              <a:gd name="connsiteY2" fmla="*/ 2589310 h 2589310"/>
              <a:gd name="connsiteX3" fmla="*/ 4157 w 2486495"/>
              <a:gd name="connsiteY3" fmla="*/ 1698755 h 2589310"/>
              <a:gd name="connsiteX4" fmla="*/ 0 w 2486495"/>
              <a:gd name="connsiteY4" fmla="*/ 1328943 h 2589310"/>
              <a:gd name="connsiteX0" fmla="*/ 0 w 2486495"/>
              <a:gd name="connsiteY0" fmla="*/ 1328943 h 2589310"/>
              <a:gd name="connsiteX1" fmla="*/ 2486495 w 2486495"/>
              <a:gd name="connsiteY1" fmla="*/ 0 h 2589310"/>
              <a:gd name="connsiteX2" fmla="*/ 2486495 w 2486495"/>
              <a:gd name="connsiteY2" fmla="*/ 2589310 h 2589310"/>
              <a:gd name="connsiteX3" fmla="*/ 4157 w 2486495"/>
              <a:gd name="connsiteY3" fmla="*/ 2335956 h 2589310"/>
              <a:gd name="connsiteX4" fmla="*/ 0 w 2486495"/>
              <a:gd name="connsiteY4" fmla="*/ 1328943 h 2589310"/>
              <a:gd name="connsiteX0" fmla="*/ 0 w 2489868"/>
              <a:gd name="connsiteY0" fmla="*/ 1956772 h 2589310"/>
              <a:gd name="connsiteX1" fmla="*/ 2489868 w 2489868"/>
              <a:gd name="connsiteY1" fmla="*/ 0 h 2589310"/>
              <a:gd name="connsiteX2" fmla="*/ 2489868 w 2489868"/>
              <a:gd name="connsiteY2" fmla="*/ 2589310 h 2589310"/>
              <a:gd name="connsiteX3" fmla="*/ 7530 w 2489868"/>
              <a:gd name="connsiteY3" fmla="*/ 2335956 h 2589310"/>
              <a:gd name="connsiteX4" fmla="*/ 0 w 2489868"/>
              <a:gd name="connsiteY4" fmla="*/ 1956772 h 258931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2489868" h="2589310">
                <a:moveTo>
                  <a:pt x="0" y="1956772"/>
                </a:moveTo>
                <a:lnTo>
                  <a:pt x="2489868" y="0"/>
                </a:lnTo>
                <a:lnTo>
                  <a:pt x="2489868" y="2589310"/>
                </a:lnTo>
                <a:lnTo>
                  <a:pt x="7530" y="2335956"/>
                </a:lnTo>
                <a:cubicBezTo>
                  <a:pt x="6144" y="2212685"/>
                  <a:pt x="1386" y="2080043"/>
                  <a:pt x="0" y="1956772"/>
                </a:cubicBez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4" name="正方形/長方形 21">
            <a:extLst>
              <a:ext uri="{FF2B5EF4-FFF2-40B4-BE49-F238E27FC236}">
                <a16:creationId xmlns:a16="http://schemas.microsoft.com/office/drawing/2014/main" id="{5F39DF8D-74DE-9D1D-5E12-B216B7192207}"/>
              </a:ext>
            </a:extLst>
          </p:cNvPr>
          <p:cNvSpPr/>
          <p:nvPr/>
        </p:nvSpPr>
        <p:spPr>
          <a:xfrm>
            <a:off x="5980864" y="6323723"/>
            <a:ext cx="907873" cy="2569523"/>
          </a:xfrm>
          <a:custGeom>
            <a:avLst/>
            <a:gdLst>
              <a:gd name="connsiteX0" fmla="*/ 0 w 2490651"/>
              <a:gd name="connsiteY0" fmla="*/ 0 h 2589310"/>
              <a:gd name="connsiteX1" fmla="*/ 2490651 w 2490651"/>
              <a:gd name="connsiteY1" fmla="*/ 0 h 2589310"/>
              <a:gd name="connsiteX2" fmla="*/ 2490651 w 2490651"/>
              <a:gd name="connsiteY2" fmla="*/ 2589310 h 2589310"/>
              <a:gd name="connsiteX3" fmla="*/ 0 w 2490651"/>
              <a:gd name="connsiteY3" fmla="*/ 2589310 h 2589310"/>
              <a:gd name="connsiteX4" fmla="*/ 0 w 2490651"/>
              <a:gd name="connsiteY4" fmla="*/ 0 h 2589310"/>
              <a:gd name="connsiteX0" fmla="*/ 0 w 2490651"/>
              <a:gd name="connsiteY0" fmla="*/ 0 h 2589310"/>
              <a:gd name="connsiteX1" fmla="*/ 2490651 w 2490651"/>
              <a:gd name="connsiteY1" fmla="*/ 0 h 2589310"/>
              <a:gd name="connsiteX2" fmla="*/ 2490651 w 2490651"/>
              <a:gd name="connsiteY2" fmla="*/ 2589310 h 2589310"/>
              <a:gd name="connsiteX3" fmla="*/ 8313 w 2490651"/>
              <a:gd name="connsiteY3" fmla="*/ 1687379 h 2589310"/>
              <a:gd name="connsiteX4" fmla="*/ 0 w 2490651"/>
              <a:gd name="connsiteY4" fmla="*/ 0 h 2589310"/>
              <a:gd name="connsiteX0" fmla="*/ 0 w 2494807"/>
              <a:gd name="connsiteY0" fmla="*/ 1309254 h 2589310"/>
              <a:gd name="connsiteX1" fmla="*/ 2494807 w 2494807"/>
              <a:gd name="connsiteY1" fmla="*/ 0 h 2589310"/>
              <a:gd name="connsiteX2" fmla="*/ 2494807 w 2494807"/>
              <a:gd name="connsiteY2" fmla="*/ 2589310 h 2589310"/>
              <a:gd name="connsiteX3" fmla="*/ 12469 w 2494807"/>
              <a:gd name="connsiteY3" fmla="*/ 1687379 h 2589310"/>
              <a:gd name="connsiteX4" fmla="*/ 0 w 2494807"/>
              <a:gd name="connsiteY4" fmla="*/ 1309254 h 2589310"/>
              <a:gd name="connsiteX0" fmla="*/ 0 w 2486495"/>
              <a:gd name="connsiteY0" fmla="*/ 1317567 h 2589310"/>
              <a:gd name="connsiteX1" fmla="*/ 2486495 w 2486495"/>
              <a:gd name="connsiteY1" fmla="*/ 0 h 2589310"/>
              <a:gd name="connsiteX2" fmla="*/ 2486495 w 2486495"/>
              <a:gd name="connsiteY2" fmla="*/ 2589310 h 2589310"/>
              <a:gd name="connsiteX3" fmla="*/ 4157 w 2486495"/>
              <a:gd name="connsiteY3" fmla="*/ 1687379 h 2589310"/>
              <a:gd name="connsiteX4" fmla="*/ 0 w 2486495"/>
              <a:gd name="connsiteY4" fmla="*/ 1317567 h 2589310"/>
              <a:gd name="connsiteX0" fmla="*/ 0 w 2486495"/>
              <a:gd name="connsiteY0" fmla="*/ 1328943 h 2589310"/>
              <a:gd name="connsiteX1" fmla="*/ 2486495 w 2486495"/>
              <a:gd name="connsiteY1" fmla="*/ 0 h 2589310"/>
              <a:gd name="connsiteX2" fmla="*/ 2486495 w 2486495"/>
              <a:gd name="connsiteY2" fmla="*/ 2589310 h 2589310"/>
              <a:gd name="connsiteX3" fmla="*/ 4157 w 2486495"/>
              <a:gd name="connsiteY3" fmla="*/ 1687379 h 2589310"/>
              <a:gd name="connsiteX4" fmla="*/ 0 w 2486495"/>
              <a:gd name="connsiteY4" fmla="*/ 1328943 h 2589310"/>
              <a:gd name="connsiteX0" fmla="*/ 0 w 2486495"/>
              <a:gd name="connsiteY0" fmla="*/ 1328943 h 2589310"/>
              <a:gd name="connsiteX1" fmla="*/ 2486495 w 2486495"/>
              <a:gd name="connsiteY1" fmla="*/ 0 h 2589310"/>
              <a:gd name="connsiteX2" fmla="*/ 2486495 w 2486495"/>
              <a:gd name="connsiteY2" fmla="*/ 2589310 h 2589310"/>
              <a:gd name="connsiteX3" fmla="*/ 4157 w 2486495"/>
              <a:gd name="connsiteY3" fmla="*/ 1707287 h 2589310"/>
              <a:gd name="connsiteX4" fmla="*/ 0 w 2486495"/>
              <a:gd name="connsiteY4" fmla="*/ 1328943 h 2589310"/>
              <a:gd name="connsiteX0" fmla="*/ 0 w 2486495"/>
              <a:gd name="connsiteY0" fmla="*/ 1328943 h 2589310"/>
              <a:gd name="connsiteX1" fmla="*/ 2486495 w 2486495"/>
              <a:gd name="connsiteY1" fmla="*/ 0 h 2589310"/>
              <a:gd name="connsiteX2" fmla="*/ 2486495 w 2486495"/>
              <a:gd name="connsiteY2" fmla="*/ 2589310 h 2589310"/>
              <a:gd name="connsiteX3" fmla="*/ 4157 w 2486495"/>
              <a:gd name="connsiteY3" fmla="*/ 1698755 h 2589310"/>
              <a:gd name="connsiteX4" fmla="*/ 0 w 2486495"/>
              <a:gd name="connsiteY4" fmla="*/ 1328943 h 2589310"/>
              <a:gd name="connsiteX0" fmla="*/ 12493 w 2482429"/>
              <a:gd name="connsiteY0" fmla="*/ 1053429 h 2589310"/>
              <a:gd name="connsiteX1" fmla="*/ 2482429 w 2482429"/>
              <a:gd name="connsiteY1" fmla="*/ 0 h 2589310"/>
              <a:gd name="connsiteX2" fmla="*/ 2482429 w 2482429"/>
              <a:gd name="connsiteY2" fmla="*/ 2589310 h 2589310"/>
              <a:gd name="connsiteX3" fmla="*/ 91 w 2482429"/>
              <a:gd name="connsiteY3" fmla="*/ 1698755 h 2589310"/>
              <a:gd name="connsiteX4" fmla="*/ 12493 w 2482429"/>
              <a:gd name="connsiteY4" fmla="*/ 1053429 h 2589310"/>
              <a:gd name="connsiteX0" fmla="*/ 4309 w 2474245"/>
              <a:gd name="connsiteY0" fmla="*/ 1053429 h 2589310"/>
              <a:gd name="connsiteX1" fmla="*/ 2474245 w 2474245"/>
              <a:gd name="connsiteY1" fmla="*/ 0 h 2589310"/>
              <a:gd name="connsiteX2" fmla="*/ 2474245 w 2474245"/>
              <a:gd name="connsiteY2" fmla="*/ 2589310 h 2589310"/>
              <a:gd name="connsiteX3" fmla="*/ 185 w 2474245"/>
              <a:gd name="connsiteY3" fmla="*/ 1426303 h 2589310"/>
              <a:gd name="connsiteX4" fmla="*/ 4309 w 2474245"/>
              <a:gd name="connsiteY4" fmla="*/ 1053429 h 258931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2474245" h="2589310">
                <a:moveTo>
                  <a:pt x="4309" y="1053429"/>
                </a:moveTo>
                <a:lnTo>
                  <a:pt x="2474245" y="0"/>
                </a:lnTo>
                <a:lnTo>
                  <a:pt x="2474245" y="2589310"/>
                </a:lnTo>
                <a:lnTo>
                  <a:pt x="185" y="1426303"/>
                </a:lnTo>
                <a:cubicBezTo>
                  <a:pt x="-1201" y="1303032"/>
                  <a:pt x="5695" y="1176700"/>
                  <a:pt x="4309" y="1053429"/>
                </a:cubicBez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03E18D96-44A3-B69A-9714-DB85A8346D67}"/>
              </a:ext>
            </a:extLst>
          </p:cNvPr>
          <p:cNvSpPr txBox="1"/>
          <p:nvPr/>
        </p:nvSpPr>
        <p:spPr>
          <a:xfrm>
            <a:off x="2168121" y="5728917"/>
            <a:ext cx="6319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/>
              <a:t>500µm</a:t>
            </a:r>
            <a:endParaRPr kumimoji="1" lang="ja-JP" altLang="en-US" sz="1200" b="1" dirty="0"/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4235BE24-F891-0DCC-9D49-9380A668C9B4}"/>
              </a:ext>
            </a:extLst>
          </p:cNvPr>
          <p:cNvSpPr txBox="1"/>
          <p:nvPr/>
        </p:nvSpPr>
        <p:spPr>
          <a:xfrm>
            <a:off x="2168121" y="8515129"/>
            <a:ext cx="6319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/>
              <a:t>500µm</a:t>
            </a:r>
            <a:endParaRPr kumimoji="1" lang="ja-JP" altLang="en-US" sz="1200" b="1" dirty="0"/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1AC5C8C3-C1B2-A435-52C0-A3957FB72439}"/>
              </a:ext>
            </a:extLst>
          </p:cNvPr>
          <p:cNvSpPr txBox="1"/>
          <p:nvPr/>
        </p:nvSpPr>
        <p:spPr>
          <a:xfrm>
            <a:off x="2168121" y="2936476"/>
            <a:ext cx="6319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/>
              <a:t>500µm</a:t>
            </a:r>
            <a:endParaRPr kumimoji="1" lang="ja-JP" altLang="en-US" sz="1200" b="1" dirty="0"/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FF89DFE7-8BD1-1CB1-3546-B2854F30578B}"/>
              </a:ext>
            </a:extLst>
          </p:cNvPr>
          <p:cNvSpPr txBox="1"/>
          <p:nvPr/>
        </p:nvSpPr>
        <p:spPr>
          <a:xfrm>
            <a:off x="6906950" y="5728917"/>
            <a:ext cx="5533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/>
              <a:t>50µm</a:t>
            </a:r>
            <a:endParaRPr kumimoji="1" lang="ja-JP" altLang="en-US" sz="1200" b="1" dirty="0"/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C5EF589D-3AFA-710C-F0D0-2EF95C735CE0}"/>
              </a:ext>
            </a:extLst>
          </p:cNvPr>
          <p:cNvSpPr txBox="1"/>
          <p:nvPr/>
        </p:nvSpPr>
        <p:spPr>
          <a:xfrm>
            <a:off x="6906950" y="8515129"/>
            <a:ext cx="5533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/>
              <a:t>50µm</a:t>
            </a:r>
            <a:endParaRPr kumimoji="1" lang="ja-JP" altLang="en-US" sz="1200" b="1" dirty="0"/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486BE7F0-A908-9592-7872-CA9D79048D0E}"/>
              </a:ext>
            </a:extLst>
          </p:cNvPr>
          <p:cNvSpPr txBox="1"/>
          <p:nvPr/>
        </p:nvSpPr>
        <p:spPr>
          <a:xfrm>
            <a:off x="6906950" y="2936476"/>
            <a:ext cx="5533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/>
              <a:t>50µm</a:t>
            </a:r>
            <a:endParaRPr kumimoji="1" lang="ja-JP" altLang="en-US" sz="1200" b="1" dirty="0"/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1519ACA6-F8CF-1BAD-7672-08B90B0B5248}"/>
              </a:ext>
            </a:extLst>
          </p:cNvPr>
          <p:cNvSpPr txBox="1"/>
          <p:nvPr/>
        </p:nvSpPr>
        <p:spPr>
          <a:xfrm>
            <a:off x="11632803" y="7156965"/>
            <a:ext cx="4369195" cy="1600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3. 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Representative images of immunohistochemistry for TIM-3 in CRC tissues. TIM-3 was found to be expressed mainly by immune cells with macrophage-like morphology in tumor center (upper panels), tumor invasive front (middle panels) and lymphoid structure in the tumor microenvironment (lower panels).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55D677C8-8268-2D72-0282-290B11EC43F1}"/>
              </a:ext>
            </a:extLst>
          </p:cNvPr>
          <p:cNvSpPr txBox="1"/>
          <p:nvPr/>
        </p:nvSpPr>
        <p:spPr>
          <a:xfrm>
            <a:off x="1048442" y="867180"/>
            <a:ext cx="102261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Tumor center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A61924DE-FCD4-2235-B02C-71D215F3A34F}"/>
              </a:ext>
            </a:extLst>
          </p:cNvPr>
          <p:cNvSpPr txBox="1"/>
          <p:nvPr/>
        </p:nvSpPr>
        <p:spPr>
          <a:xfrm>
            <a:off x="1004543" y="3701119"/>
            <a:ext cx="111041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Invasive front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05263262-0B2A-61AF-A8E9-6D90C654D09B}"/>
              </a:ext>
            </a:extLst>
          </p:cNvPr>
          <p:cNvSpPr txBox="1"/>
          <p:nvPr/>
        </p:nvSpPr>
        <p:spPr>
          <a:xfrm>
            <a:off x="876953" y="6517089"/>
            <a:ext cx="136559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Lymphoid structure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3495271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75925860-6594-F94C-E75B-12AAEA329BBE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46321" y="4780289"/>
            <a:ext cx="4932769" cy="312408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id="{59EA8DFD-684F-2A16-9EB5-0B0A2E20FAC1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46321" y="848387"/>
            <a:ext cx="4932769" cy="312408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3" name="図 22">
            <a:extLst>
              <a:ext uri="{FF2B5EF4-FFF2-40B4-BE49-F238E27FC236}">
                <a16:creationId xmlns:a16="http://schemas.microsoft.com/office/drawing/2014/main" id="{8C83A189-4789-B3EE-98DC-960562649D48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3300" y="4780288"/>
            <a:ext cx="4932769" cy="3124087"/>
          </a:xfrm>
          <a:prstGeom prst="rect">
            <a:avLst/>
          </a:prstGeom>
          <a:ln w="38100">
            <a:solidFill>
              <a:srgbClr val="FF0000"/>
            </a:solidFill>
          </a:ln>
        </p:spPr>
      </p:pic>
      <p:pic>
        <p:nvPicPr>
          <p:cNvPr id="25" name="図 24">
            <a:extLst>
              <a:ext uri="{FF2B5EF4-FFF2-40B4-BE49-F238E27FC236}">
                <a16:creationId xmlns:a16="http://schemas.microsoft.com/office/drawing/2014/main" id="{721D0E4A-247F-BFB6-0A9E-A3074B9333CA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3300" y="848388"/>
            <a:ext cx="4932769" cy="3124087"/>
          </a:xfrm>
          <a:prstGeom prst="rect">
            <a:avLst/>
          </a:prstGeom>
          <a:ln w="38100">
            <a:solidFill>
              <a:srgbClr val="FF0000"/>
            </a:solidFill>
          </a:ln>
        </p:spPr>
      </p:pic>
      <p:pic>
        <p:nvPicPr>
          <p:cNvPr id="27" name="図 26">
            <a:extLst>
              <a:ext uri="{FF2B5EF4-FFF2-40B4-BE49-F238E27FC236}">
                <a16:creationId xmlns:a16="http://schemas.microsoft.com/office/drawing/2014/main" id="{EC5570BC-361C-0326-B91D-024EDC5CB550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759342" y="848388"/>
            <a:ext cx="4932769" cy="3124087"/>
          </a:xfrm>
          <a:prstGeom prst="rect">
            <a:avLst/>
          </a:prstGeom>
          <a:ln w="38100">
            <a:solidFill>
              <a:srgbClr val="0070C0"/>
            </a:solidFill>
          </a:ln>
        </p:spPr>
      </p:pic>
      <p:pic>
        <p:nvPicPr>
          <p:cNvPr id="29" name="図 28">
            <a:extLst>
              <a:ext uri="{FF2B5EF4-FFF2-40B4-BE49-F238E27FC236}">
                <a16:creationId xmlns:a16="http://schemas.microsoft.com/office/drawing/2014/main" id="{20661564-8828-A6D9-0931-EC7D470C52C9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759342" y="4780289"/>
            <a:ext cx="4932769" cy="3124087"/>
          </a:xfrm>
          <a:prstGeom prst="rect">
            <a:avLst/>
          </a:prstGeom>
          <a:ln w="38100">
            <a:solidFill>
              <a:srgbClr val="0070C0"/>
            </a:solidFill>
          </a:ln>
        </p:spPr>
      </p:pic>
      <p:sp>
        <p:nvSpPr>
          <p:cNvPr id="30" name="正方形/長方形 29">
            <a:extLst>
              <a:ext uri="{FF2B5EF4-FFF2-40B4-BE49-F238E27FC236}">
                <a16:creationId xmlns:a16="http://schemas.microsoft.com/office/drawing/2014/main" id="{844A788F-E3CB-4231-1D44-7C811AF1E3DA}"/>
              </a:ext>
            </a:extLst>
          </p:cNvPr>
          <p:cNvSpPr/>
          <p:nvPr/>
        </p:nvSpPr>
        <p:spPr>
          <a:xfrm>
            <a:off x="6852090" y="2508399"/>
            <a:ext cx="239787" cy="161311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1" name="正方形/長方形 30">
            <a:extLst>
              <a:ext uri="{FF2B5EF4-FFF2-40B4-BE49-F238E27FC236}">
                <a16:creationId xmlns:a16="http://schemas.microsoft.com/office/drawing/2014/main" id="{528B9CA6-0875-8FCD-D38B-FBC81CE04279}"/>
              </a:ext>
            </a:extLst>
          </p:cNvPr>
          <p:cNvSpPr/>
          <p:nvPr/>
        </p:nvSpPr>
        <p:spPr>
          <a:xfrm>
            <a:off x="6829590" y="6444112"/>
            <a:ext cx="239787" cy="161311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2" name="正方形/長方形 31">
            <a:extLst>
              <a:ext uri="{FF2B5EF4-FFF2-40B4-BE49-F238E27FC236}">
                <a16:creationId xmlns:a16="http://schemas.microsoft.com/office/drawing/2014/main" id="{AD37196F-90D0-8000-6FAD-8BEFEAD9D8CE}"/>
              </a:ext>
            </a:extLst>
          </p:cNvPr>
          <p:cNvSpPr/>
          <p:nvPr/>
        </p:nvSpPr>
        <p:spPr>
          <a:xfrm>
            <a:off x="9307806" y="2416857"/>
            <a:ext cx="239787" cy="161311"/>
          </a:xfrm>
          <a:prstGeom prst="rect">
            <a:avLst/>
          </a:prstGeom>
          <a:noFill/>
          <a:ln w="381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3" name="正方形/長方形 32">
            <a:extLst>
              <a:ext uri="{FF2B5EF4-FFF2-40B4-BE49-F238E27FC236}">
                <a16:creationId xmlns:a16="http://schemas.microsoft.com/office/drawing/2014/main" id="{CC4370B2-6F6B-A82F-FE38-3C62578249F0}"/>
              </a:ext>
            </a:extLst>
          </p:cNvPr>
          <p:cNvSpPr/>
          <p:nvPr/>
        </p:nvSpPr>
        <p:spPr>
          <a:xfrm>
            <a:off x="9275837" y="6419048"/>
            <a:ext cx="239787" cy="161311"/>
          </a:xfrm>
          <a:prstGeom prst="rect">
            <a:avLst/>
          </a:prstGeom>
          <a:noFill/>
          <a:ln w="381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" name="正方形/長方形 9">
            <a:extLst>
              <a:ext uri="{FF2B5EF4-FFF2-40B4-BE49-F238E27FC236}">
                <a16:creationId xmlns:a16="http://schemas.microsoft.com/office/drawing/2014/main" id="{94D49292-8AEF-FC9F-556A-4BF7A0B545DF}"/>
              </a:ext>
            </a:extLst>
          </p:cNvPr>
          <p:cNvSpPr/>
          <p:nvPr/>
        </p:nvSpPr>
        <p:spPr>
          <a:xfrm>
            <a:off x="9547592" y="848387"/>
            <a:ext cx="1186809" cy="3124087"/>
          </a:xfrm>
          <a:custGeom>
            <a:avLst/>
            <a:gdLst>
              <a:gd name="connsiteX0" fmla="*/ 0 w 1211749"/>
              <a:gd name="connsiteY0" fmla="*/ 0 h 3124087"/>
              <a:gd name="connsiteX1" fmla="*/ 1211749 w 1211749"/>
              <a:gd name="connsiteY1" fmla="*/ 0 h 3124087"/>
              <a:gd name="connsiteX2" fmla="*/ 1211749 w 1211749"/>
              <a:gd name="connsiteY2" fmla="*/ 3124087 h 3124087"/>
              <a:gd name="connsiteX3" fmla="*/ 0 w 1211749"/>
              <a:gd name="connsiteY3" fmla="*/ 3124087 h 3124087"/>
              <a:gd name="connsiteX4" fmla="*/ 0 w 1211749"/>
              <a:gd name="connsiteY4" fmla="*/ 0 h 3124087"/>
              <a:gd name="connsiteX0" fmla="*/ 0 w 1222635"/>
              <a:gd name="connsiteY0" fmla="*/ 1545771 h 3124087"/>
              <a:gd name="connsiteX1" fmla="*/ 1222635 w 1222635"/>
              <a:gd name="connsiteY1" fmla="*/ 0 h 3124087"/>
              <a:gd name="connsiteX2" fmla="*/ 1222635 w 1222635"/>
              <a:gd name="connsiteY2" fmla="*/ 3124087 h 3124087"/>
              <a:gd name="connsiteX3" fmla="*/ 10886 w 1222635"/>
              <a:gd name="connsiteY3" fmla="*/ 3124087 h 3124087"/>
              <a:gd name="connsiteX4" fmla="*/ 0 w 1222635"/>
              <a:gd name="connsiteY4" fmla="*/ 1545771 h 3124087"/>
              <a:gd name="connsiteX0" fmla="*/ 11367 w 1234002"/>
              <a:gd name="connsiteY0" fmla="*/ 1545771 h 3124087"/>
              <a:gd name="connsiteX1" fmla="*/ 1234002 w 1234002"/>
              <a:gd name="connsiteY1" fmla="*/ 0 h 3124087"/>
              <a:gd name="connsiteX2" fmla="*/ 1234002 w 1234002"/>
              <a:gd name="connsiteY2" fmla="*/ 3124087 h 3124087"/>
              <a:gd name="connsiteX3" fmla="*/ 482 w 1234002"/>
              <a:gd name="connsiteY3" fmla="*/ 1796030 h 3124087"/>
              <a:gd name="connsiteX4" fmla="*/ 11367 w 1234002"/>
              <a:gd name="connsiteY4" fmla="*/ 1545771 h 3124087"/>
              <a:gd name="connsiteX0" fmla="*/ 0 w 1222635"/>
              <a:gd name="connsiteY0" fmla="*/ 1545771 h 3124087"/>
              <a:gd name="connsiteX1" fmla="*/ 1222635 w 1222635"/>
              <a:gd name="connsiteY1" fmla="*/ 0 h 3124087"/>
              <a:gd name="connsiteX2" fmla="*/ 1222635 w 1222635"/>
              <a:gd name="connsiteY2" fmla="*/ 3124087 h 3124087"/>
              <a:gd name="connsiteX3" fmla="*/ 5740 w 1222635"/>
              <a:gd name="connsiteY3" fmla="*/ 1721216 h 3124087"/>
              <a:gd name="connsiteX4" fmla="*/ 0 w 1222635"/>
              <a:gd name="connsiteY4" fmla="*/ 1545771 h 3124087"/>
              <a:gd name="connsiteX0" fmla="*/ 0 w 1222635"/>
              <a:gd name="connsiteY0" fmla="*/ 1545771 h 3124087"/>
              <a:gd name="connsiteX1" fmla="*/ 1222635 w 1222635"/>
              <a:gd name="connsiteY1" fmla="*/ 0 h 3124087"/>
              <a:gd name="connsiteX2" fmla="*/ 1222635 w 1222635"/>
              <a:gd name="connsiteY2" fmla="*/ 3124087 h 3124087"/>
              <a:gd name="connsiteX3" fmla="*/ 22366 w 1222635"/>
              <a:gd name="connsiteY3" fmla="*/ 1746154 h 3124087"/>
              <a:gd name="connsiteX4" fmla="*/ 0 w 1222635"/>
              <a:gd name="connsiteY4" fmla="*/ 1545771 h 3124087"/>
              <a:gd name="connsiteX0" fmla="*/ 3390 w 1226025"/>
              <a:gd name="connsiteY0" fmla="*/ 1545771 h 3124087"/>
              <a:gd name="connsiteX1" fmla="*/ 1226025 w 1226025"/>
              <a:gd name="connsiteY1" fmla="*/ 0 h 3124087"/>
              <a:gd name="connsiteX2" fmla="*/ 1226025 w 1226025"/>
              <a:gd name="connsiteY2" fmla="*/ 3124087 h 3124087"/>
              <a:gd name="connsiteX3" fmla="*/ 818 w 1226025"/>
              <a:gd name="connsiteY3" fmla="*/ 1746154 h 3124087"/>
              <a:gd name="connsiteX4" fmla="*/ 3390 w 1226025"/>
              <a:gd name="connsiteY4" fmla="*/ 1545771 h 312408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1226025" h="3124087">
                <a:moveTo>
                  <a:pt x="3390" y="1545771"/>
                </a:moveTo>
                <a:lnTo>
                  <a:pt x="1226025" y="0"/>
                </a:lnTo>
                <a:lnTo>
                  <a:pt x="1226025" y="3124087"/>
                </a:lnTo>
                <a:lnTo>
                  <a:pt x="818" y="1746154"/>
                </a:lnTo>
                <a:cubicBezTo>
                  <a:pt x="-2811" y="1220049"/>
                  <a:pt x="7019" y="2071876"/>
                  <a:pt x="3390" y="1545771"/>
                </a:cubicBezTo>
                <a:close/>
              </a:path>
            </a:pathLst>
          </a:custGeom>
          <a:noFill/>
          <a:ln w="1905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" name="正方形/長方形 9">
            <a:extLst>
              <a:ext uri="{FF2B5EF4-FFF2-40B4-BE49-F238E27FC236}">
                <a16:creationId xmlns:a16="http://schemas.microsoft.com/office/drawing/2014/main" id="{5BDA6604-F8B3-C571-A5DB-230CBBBBC8CE}"/>
              </a:ext>
            </a:extLst>
          </p:cNvPr>
          <p:cNvSpPr/>
          <p:nvPr/>
        </p:nvSpPr>
        <p:spPr>
          <a:xfrm>
            <a:off x="9515624" y="4780288"/>
            <a:ext cx="1218777" cy="3124087"/>
          </a:xfrm>
          <a:custGeom>
            <a:avLst/>
            <a:gdLst>
              <a:gd name="connsiteX0" fmla="*/ 0 w 1211749"/>
              <a:gd name="connsiteY0" fmla="*/ 0 h 3124087"/>
              <a:gd name="connsiteX1" fmla="*/ 1211749 w 1211749"/>
              <a:gd name="connsiteY1" fmla="*/ 0 h 3124087"/>
              <a:gd name="connsiteX2" fmla="*/ 1211749 w 1211749"/>
              <a:gd name="connsiteY2" fmla="*/ 3124087 h 3124087"/>
              <a:gd name="connsiteX3" fmla="*/ 0 w 1211749"/>
              <a:gd name="connsiteY3" fmla="*/ 3124087 h 3124087"/>
              <a:gd name="connsiteX4" fmla="*/ 0 w 1211749"/>
              <a:gd name="connsiteY4" fmla="*/ 0 h 3124087"/>
              <a:gd name="connsiteX0" fmla="*/ 0 w 1222635"/>
              <a:gd name="connsiteY0" fmla="*/ 1545771 h 3124087"/>
              <a:gd name="connsiteX1" fmla="*/ 1222635 w 1222635"/>
              <a:gd name="connsiteY1" fmla="*/ 0 h 3124087"/>
              <a:gd name="connsiteX2" fmla="*/ 1222635 w 1222635"/>
              <a:gd name="connsiteY2" fmla="*/ 3124087 h 3124087"/>
              <a:gd name="connsiteX3" fmla="*/ 10886 w 1222635"/>
              <a:gd name="connsiteY3" fmla="*/ 3124087 h 3124087"/>
              <a:gd name="connsiteX4" fmla="*/ 0 w 1222635"/>
              <a:gd name="connsiteY4" fmla="*/ 1545771 h 3124087"/>
              <a:gd name="connsiteX0" fmla="*/ 11367 w 1234002"/>
              <a:gd name="connsiteY0" fmla="*/ 1545771 h 3124087"/>
              <a:gd name="connsiteX1" fmla="*/ 1234002 w 1234002"/>
              <a:gd name="connsiteY1" fmla="*/ 0 h 3124087"/>
              <a:gd name="connsiteX2" fmla="*/ 1234002 w 1234002"/>
              <a:gd name="connsiteY2" fmla="*/ 3124087 h 3124087"/>
              <a:gd name="connsiteX3" fmla="*/ 482 w 1234002"/>
              <a:gd name="connsiteY3" fmla="*/ 1796030 h 3124087"/>
              <a:gd name="connsiteX4" fmla="*/ 11367 w 1234002"/>
              <a:gd name="connsiteY4" fmla="*/ 1545771 h 3124087"/>
              <a:gd name="connsiteX0" fmla="*/ 0 w 1222635"/>
              <a:gd name="connsiteY0" fmla="*/ 1545771 h 3124087"/>
              <a:gd name="connsiteX1" fmla="*/ 1222635 w 1222635"/>
              <a:gd name="connsiteY1" fmla="*/ 0 h 3124087"/>
              <a:gd name="connsiteX2" fmla="*/ 1222635 w 1222635"/>
              <a:gd name="connsiteY2" fmla="*/ 3124087 h 3124087"/>
              <a:gd name="connsiteX3" fmla="*/ 5740 w 1222635"/>
              <a:gd name="connsiteY3" fmla="*/ 1721216 h 3124087"/>
              <a:gd name="connsiteX4" fmla="*/ 0 w 1222635"/>
              <a:gd name="connsiteY4" fmla="*/ 1545771 h 3124087"/>
              <a:gd name="connsiteX0" fmla="*/ 0 w 1222635"/>
              <a:gd name="connsiteY0" fmla="*/ 1545771 h 3124087"/>
              <a:gd name="connsiteX1" fmla="*/ 1222635 w 1222635"/>
              <a:gd name="connsiteY1" fmla="*/ 0 h 3124087"/>
              <a:gd name="connsiteX2" fmla="*/ 1222635 w 1222635"/>
              <a:gd name="connsiteY2" fmla="*/ 3124087 h 3124087"/>
              <a:gd name="connsiteX3" fmla="*/ 22366 w 1222635"/>
              <a:gd name="connsiteY3" fmla="*/ 1746154 h 3124087"/>
              <a:gd name="connsiteX4" fmla="*/ 0 w 1222635"/>
              <a:gd name="connsiteY4" fmla="*/ 1545771 h 3124087"/>
              <a:gd name="connsiteX0" fmla="*/ 3390 w 1226025"/>
              <a:gd name="connsiteY0" fmla="*/ 1545771 h 3124087"/>
              <a:gd name="connsiteX1" fmla="*/ 1226025 w 1226025"/>
              <a:gd name="connsiteY1" fmla="*/ 0 h 3124087"/>
              <a:gd name="connsiteX2" fmla="*/ 1226025 w 1226025"/>
              <a:gd name="connsiteY2" fmla="*/ 3124087 h 3124087"/>
              <a:gd name="connsiteX3" fmla="*/ 818 w 1226025"/>
              <a:gd name="connsiteY3" fmla="*/ 1746154 h 3124087"/>
              <a:gd name="connsiteX4" fmla="*/ 3390 w 1226025"/>
              <a:gd name="connsiteY4" fmla="*/ 1545771 h 3124087"/>
              <a:gd name="connsiteX0" fmla="*/ 0 w 1222635"/>
              <a:gd name="connsiteY0" fmla="*/ 1545771 h 3124087"/>
              <a:gd name="connsiteX1" fmla="*/ 1222635 w 1222635"/>
              <a:gd name="connsiteY1" fmla="*/ 0 h 3124087"/>
              <a:gd name="connsiteX2" fmla="*/ 1222635 w 1222635"/>
              <a:gd name="connsiteY2" fmla="*/ 3124087 h 3124087"/>
              <a:gd name="connsiteX3" fmla="*/ 14053 w 1222635"/>
              <a:gd name="connsiteY3" fmla="*/ 1804343 h 3124087"/>
              <a:gd name="connsiteX4" fmla="*/ 0 w 1222635"/>
              <a:gd name="connsiteY4" fmla="*/ 1545771 h 3124087"/>
              <a:gd name="connsiteX0" fmla="*/ 3391 w 1209401"/>
              <a:gd name="connsiteY0" fmla="*/ 1612273 h 3124087"/>
              <a:gd name="connsiteX1" fmla="*/ 1209401 w 1209401"/>
              <a:gd name="connsiteY1" fmla="*/ 0 h 3124087"/>
              <a:gd name="connsiteX2" fmla="*/ 1209401 w 1209401"/>
              <a:gd name="connsiteY2" fmla="*/ 3124087 h 3124087"/>
              <a:gd name="connsiteX3" fmla="*/ 819 w 1209401"/>
              <a:gd name="connsiteY3" fmla="*/ 1804343 h 3124087"/>
              <a:gd name="connsiteX4" fmla="*/ 3391 w 1209401"/>
              <a:gd name="connsiteY4" fmla="*/ 1612273 h 3124087"/>
              <a:gd name="connsiteX0" fmla="*/ 0 w 1230948"/>
              <a:gd name="connsiteY0" fmla="*/ 1637211 h 3124087"/>
              <a:gd name="connsiteX1" fmla="*/ 1230948 w 1230948"/>
              <a:gd name="connsiteY1" fmla="*/ 0 h 3124087"/>
              <a:gd name="connsiteX2" fmla="*/ 1230948 w 1230948"/>
              <a:gd name="connsiteY2" fmla="*/ 3124087 h 3124087"/>
              <a:gd name="connsiteX3" fmla="*/ 22366 w 1230948"/>
              <a:gd name="connsiteY3" fmla="*/ 1804343 h 3124087"/>
              <a:gd name="connsiteX4" fmla="*/ 0 w 1230948"/>
              <a:gd name="connsiteY4" fmla="*/ 1637211 h 3124087"/>
              <a:gd name="connsiteX0" fmla="*/ 0 w 1222636"/>
              <a:gd name="connsiteY0" fmla="*/ 1637211 h 3124087"/>
              <a:gd name="connsiteX1" fmla="*/ 1222636 w 1222636"/>
              <a:gd name="connsiteY1" fmla="*/ 0 h 3124087"/>
              <a:gd name="connsiteX2" fmla="*/ 1222636 w 1222636"/>
              <a:gd name="connsiteY2" fmla="*/ 3124087 h 3124087"/>
              <a:gd name="connsiteX3" fmla="*/ 14054 w 1222636"/>
              <a:gd name="connsiteY3" fmla="*/ 1804343 h 3124087"/>
              <a:gd name="connsiteX4" fmla="*/ 0 w 1222636"/>
              <a:gd name="connsiteY4" fmla="*/ 1637211 h 3124087"/>
              <a:gd name="connsiteX0" fmla="*/ 11367 w 1234003"/>
              <a:gd name="connsiteY0" fmla="*/ 1637211 h 3124087"/>
              <a:gd name="connsiteX1" fmla="*/ 1234003 w 1234003"/>
              <a:gd name="connsiteY1" fmla="*/ 0 h 3124087"/>
              <a:gd name="connsiteX2" fmla="*/ 1234003 w 1234003"/>
              <a:gd name="connsiteY2" fmla="*/ 3124087 h 3124087"/>
              <a:gd name="connsiteX3" fmla="*/ 482 w 1234003"/>
              <a:gd name="connsiteY3" fmla="*/ 1804343 h 3124087"/>
              <a:gd name="connsiteX4" fmla="*/ 11367 w 1234003"/>
              <a:gd name="connsiteY4" fmla="*/ 1637211 h 312408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1234003" h="3124087">
                <a:moveTo>
                  <a:pt x="11367" y="1637211"/>
                </a:moveTo>
                <a:lnTo>
                  <a:pt x="1234003" y="0"/>
                </a:lnTo>
                <a:lnTo>
                  <a:pt x="1234003" y="3124087"/>
                </a:lnTo>
                <a:lnTo>
                  <a:pt x="482" y="1804343"/>
                </a:lnTo>
                <a:cubicBezTo>
                  <a:pt x="-3147" y="1278238"/>
                  <a:pt x="14996" y="2163316"/>
                  <a:pt x="11367" y="1637211"/>
                </a:cubicBezTo>
                <a:close/>
              </a:path>
            </a:pathLst>
          </a:custGeom>
          <a:noFill/>
          <a:ln w="1905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" name="正方形/長方形 9">
            <a:extLst>
              <a:ext uri="{FF2B5EF4-FFF2-40B4-BE49-F238E27FC236}">
                <a16:creationId xmlns:a16="http://schemas.microsoft.com/office/drawing/2014/main" id="{12E30378-0D10-FEEA-8AB5-82628792247C}"/>
              </a:ext>
            </a:extLst>
          </p:cNvPr>
          <p:cNvSpPr/>
          <p:nvPr/>
        </p:nvSpPr>
        <p:spPr>
          <a:xfrm flipH="1">
            <a:off x="5486970" y="848387"/>
            <a:ext cx="1365126" cy="3124087"/>
          </a:xfrm>
          <a:custGeom>
            <a:avLst/>
            <a:gdLst>
              <a:gd name="connsiteX0" fmla="*/ 0 w 1211749"/>
              <a:gd name="connsiteY0" fmla="*/ 0 h 3124087"/>
              <a:gd name="connsiteX1" fmla="*/ 1211749 w 1211749"/>
              <a:gd name="connsiteY1" fmla="*/ 0 h 3124087"/>
              <a:gd name="connsiteX2" fmla="*/ 1211749 w 1211749"/>
              <a:gd name="connsiteY2" fmla="*/ 3124087 h 3124087"/>
              <a:gd name="connsiteX3" fmla="*/ 0 w 1211749"/>
              <a:gd name="connsiteY3" fmla="*/ 3124087 h 3124087"/>
              <a:gd name="connsiteX4" fmla="*/ 0 w 1211749"/>
              <a:gd name="connsiteY4" fmla="*/ 0 h 3124087"/>
              <a:gd name="connsiteX0" fmla="*/ 0 w 1222635"/>
              <a:gd name="connsiteY0" fmla="*/ 1545771 h 3124087"/>
              <a:gd name="connsiteX1" fmla="*/ 1222635 w 1222635"/>
              <a:gd name="connsiteY1" fmla="*/ 0 h 3124087"/>
              <a:gd name="connsiteX2" fmla="*/ 1222635 w 1222635"/>
              <a:gd name="connsiteY2" fmla="*/ 3124087 h 3124087"/>
              <a:gd name="connsiteX3" fmla="*/ 10886 w 1222635"/>
              <a:gd name="connsiteY3" fmla="*/ 3124087 h 3124087"/>
              <a:gd name="connsiteX4" fmla="*/ 0 w 1222635"/>
              <a:gd name="connsiteY4" fmla="*/ 1545771 h 3124087"/>
              <a:gd name="connsiteX0" fmla="*/ 11367 w 1234002"/>
              <a:gd name="connsiteY0" fmla="*/ 1545771 h 3124087"/>
              <a:gd name="connsiteX1" fmla="*/ 1234002 w 1234002"/>
              <a:gd name="connsiteY1" fmla="*/ 0 h 3124087"/>
              <a:gd name="connsiteX2" fmla="*/ 1234002 w 1234002"/>
              <a:gd name="connsiteY2" fmla="*/ 3124087 h 3124087"/>
              <a:gd name="connsiteX3" fmla="*/ 482 w 1234002"/>
              <a:gd name="connsiteY3" fmla="*/ 1796030 h 3124087"/>
              <a:gd name="connsiteX4" fmla="*/ 11367 w 1234002"/>
              <a:gd name="connsiteY4" fmla="*/ 1545771 h 3124087"/>
              <a:gd name="connsiteX0" fmla="*/ 0 w 1222635"/>
              <a:gd name="connsiteY0" fmla="*/ 1545771 h 3124087"/>
              <a:gd name="connsiteX1" fmla="*/ 1222635 w 1222635"/>
              <a:gd name="connsiteY1" fmla="*/ 0 h 3124087"/>
              <a:gd name="connsiteX2" fmla="*/ 1222635 w 1222635"/>
              <a:gd name="connsiteY2" fmla="*/ 3124087 h 3124087"/>
              <a:gd name="connsiteX3" fmla="*/ 5740 w 1222635"/>
              <a:gd name="connsiteY3" fmla="*/ 1721216 h 3124087"/>
              <a:gd name="connsiteX4" fmla="*/ 0 w 1222635"/>
              <a:gd name="connsiteY4" fmla="*/ 1545771 h 3124087"/>
              <a:gd name="connsiteX0" fmla="*/ 0 w 1222635"/>
              <a:gd name="connsiteY0" fmla="*/ 1545771 h 3124087"/>
              <a:gd name="connsiteX1" fmla="*/ 1222635 w 1222635"/>
              <a:gd name="connsiteY1" fmla="*/ 0 h 3124087"/>
              <a:gd name="connsiteX2" fmla="*/ 1222635 w 1222635"/>
              <a:gd name="connsiteY2" fmla="*/ 3124087 h 3124087"/>
              <a:gd name="connsiteX3" fmla="*/ 22366 w 1222635"/>
              <a:gd name="connsiteY3" fmla="*/ 1746154 h 3124087"/>
              <a:gd name="connsiteX4" fmla="*/ 0 w 1222635"/>
              <a:gd name="connsiteY4" fmla="*/ 1545771 h 3124087"/>
              <a:gd name="connsiteX0" fmla="*/ 3390 w 1226025"/>
              <a:gd name="connsiteY0" fmla="*/ 1545771 h 3124087"/>
              <a:gd name="connsiteX1" fmla="*/ 1226025 w 1226025"/>
              <a:gd name="connsiteY1" fmla="*/ 0 h 3124087"/>
              <a:gd name="connsiteX2" fmla="*/ 1226025 w 1226025"/>
              <a:gd name="connsiteY2" fmla="*/ 3124087 h 3124087"/>
              <a:gd name="connsiteX3" fmla="*/ 818 w 1226025"/>
              <a:gd name="connsiteY3" fmla="*/ 1746154 h 3124087"/>
              <a:gd name="connsiteX4" fmla="*/ 3390 w 1226025"/>
              <a:gd name="connsiteY4" fmla="*/ 1545771 h 3124087"/>
              <a:gd name="connsiteX0" fmla="*/ 3390 w 1226025"/>
              <a:gd name="connsiteY0" fmla="*/ 1545771 h 3124087"/>
              <a:gd name="connsiteX1" fmla="*/ 1226025 w 1226025"/>
              <a:gd name="connsiteY1" fmla="*/ 0 h 3124087"/>
              <a:gd name="connsiteX2" fmla="*/ 1226025 w 1226025"/>
              <a:gd name="connsiteY2" fmla="*/ 3124087 h 3124087"/>
              <a:gd name="connsiteX3" fmla="*/ 818 w 1226025"/>
              <a:gd name="connsiteY3" fmla="*/ 1824531 h 3124087"/>
              <a:gd name="connsiteX4" fmla="*/ 3390 w 1226025"/>
              <a:gd name="connsiteY4" fmla="*/ 1545771 h 3124087"/>
              <a:gd name="connsiteX0" fmla="*/ 0 w 1230485"/>
              <a:gd name="connsiteY0" fmla="*/ 1624148 h 3124087"/>
              <a:gd name="connsiteX1" fmla="*/ 1230485 w 1230485"/>
              <a:gd name="connsiteY1" fmla="*/ 0 h 3124087"/>
              <a:gd name="connsiteX2" fmla="*/ 1230485 w 1230485"/>
              <a:gd name="connsiteY2" fmla="*/ 3124087 h 3124087"/>
              <a:gd name="connsiteX3" fmla="*/ 5278 w 1230485"/>
              <a:gd name="connsiteY3" fmla="*/ 1824531 h 3124087"/>
              <a:gd name="connsiteX4" fmla="*/ 0 w 1230485"/>
              <a:gd name="connsiteY4" fmla="*/ 1624148 h 3124087"/>
              <a:gd name="connsiteX0" fmla="*/ 0 w 1230485"/>
              <a:gd name="connsiteY0" fmla="*/ 1624148 h 3124087"/>
              <a:gd name="connsiteX1" fmla="*/ 1230485 w 1230485"/>
              <a:gd name="connsiteY1" fmla="*/ 0 h 3124087"/>
              <a:gd name="connsiteX2" fmla="*/ 1230485 w 1230485"/>
              <a:gd name="connsiteY2" fmla="*/ 3124087 h 3124087"/>
              <a:gd name="connsiteX3" fmla="*/ 5278 w 1230485"/>
              <a:gd name="connsiteY3" fmla="*/ 1824531 h 3124087"/>
              <a:gd name="connsiteX4" fmla="*/ 0 w 1230485"/>
              <a:gd name="connsiteY4" fmla="*/ 1624148 h 3124087"/>
              <a:gd name="connsiteX0" fmla="*/ 0 w 1230485"/>
              <a:gd name="connsiteY0" fmla="*/ 1667690 h 3124087"/>
              <a:gd name="connsiteX1" fmla="*/ 1230485 w 1230485"/>
              <a:gd name="connsiteY1" fmla="*/ 0 h 3124087"/>
              <a:gd name="connsiteX2" fmla="*/ 1230485 w 1230485"/>
              <a:gd name="connsiteY2" fmla="*/ 3124087 h 3124087"/>
              <a:gd name="connsiteX3" fmla="*/ 5278 w 1230485"/>
              <a:gd name="connsiteY3" fmla="*/ 1824531 h 3124087"/>
              <a:gd name="connsiteX4" fmla="*/ 0 w 1230485"/>
              <a:gd name="connsiteY4" fmla="*/ 1667690 h 312408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1230485" h="3124087">
                <a:moveTo>
                  <a:pt x="0" y="1667690"/>
                </a:moveTo>
                <a:lnTo>
                  <a:pt x="1230485" y="0"/>
                </a:lnTo>
                <a:lnTo>
                  <a:pt x="1230485" y="3124087"/>
                </a:lnTo>
                <a:lnTo>
                  <a:pt x="5278" y="1824531"/>
                </a:lnTo>
                <a:cubicBezTo>
                  <a:pt x="1649" y="1298426"/>
                  <a:pt x="3629" y="2193795"/>
                  <a:pt x="0" y="1667690"/>
                </a:cubicBezTo>
                <a:close/>
              </a:path>
            </a:pathLst>
          </a:cu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" name="正方形/長方形 9">
            <a:extLst>
              <a:ext uri="{FF2B5EF4-FFF2-40B4-BE49-F238E27FC236}">
                <a16:creationId xmlns:a16="http://schemas.microsoft.com/office/drawing/2014/main" id="{CA90E48A-A728-EA11-04B6-74F883D8CD47}"/>
              </a:ext>
            </a:extLst>
          </p:cNvPr>
          <p:cNvSpPr/>
          <p:nvPr/>
        </p:nvSpPr>
        <p:spPr>
          <a:xfrm flipH="1">
            <a:off x="5483303" y="4780288"/>
            <a:ext cx="1346285" cy="3124087"/>
          </a:xfrm>
          <a:custGeom>
            <a:avLst/>
            <a:gdLst>
              <a:gd name="connsiteX0" fmla="*/ 0 w 1211749"/>
              <a:gd name="connsiteY0" fmla="*/ 0 h 3124087"/>
              <a:gd name="connsiteX1" fmla="*/ 1211749 w 1211749"/>
              <a:gd name="connsiteY1" fmla="*/ 0 h 3124087"/>
              <a:gd name="connsiteX2" fmla="*/ 1211749 w 1211749"/>
              <a:gd name="connsiteY2" fmla="*/ 3124087 h 3124087"/>
              <a:gd name="connsiteX3" fmla="*/ 0 w 1211749"/>
              <a:gd name="connsiteY3" fmla="*/ 3124087 h 3124087"/>
              <a:gd name="connsiteX4" fmla="*/ 0 w 1211749"/>
              <a:gd name="connsiteY4" fmla="*/ 0 h 3124087"/>
              <a:gd name="connsiteX0" fmla="*/ 0 w 1222635"/>
              <a:gd name="connsiteY0" fmla="*/ 1545771 h 3124087"/>
              <a:gd name="connsiteX1" fmla="*/ 1222635 w 1222635"/>
              <a:gd name="connsiteY1" fmla="*/ 0 h 3124087"/>
              <a:gd name="connsiteX2" fmla="*/ 1222635 w 1222635"/>
              <a:gd name="connsiteY2" fmla="*/ 3124087 h 3124087"/>
              <a:gd name="connsiteX3" fmla="*/ 10886 w 1222635"/>
              <a:gd name="connsiteY3" fmla="*/ 3124087 h 3124087"/>
              <a:gd name="connsiteX4" fmla="*/ 0 w 1222635"/>
              <a:gd name="connsiteY4" fmla="*/ 1545771 h 3124087"/>
              <a:gd name="connsiteX0" fmla="*/ 11367 w 1234002"/>
              <a:gd name="connsiteY0" fmla="*/ 1545771 h 3124087"/>
              <a:gd name="connsiteX1" fmla="*/ 1234002 w 1234002"/>
              <a:gd name="connsiteY1" fmla="*/ 0 h 3124087"/>
              <a:gd name="connsiteX2" fmla="*/ 1234002 w 1234002"/>
              <a:gd name="connsiteY2" fmla="*/ 3124087 h 3124087"/>
              <a:gd name="connsiteX3" fmla="*/ 482 w 1234002"/>
              <a:gd name="connsiteY3" fmla="*/ 1796030 h 3124087"/>
              <a:gd name="connsiteX4" fmla="*/ 11367 w 1234002"/>
              <a:gd name="connsiteY4" fmla="*/ 1545771 h 3124087"/>
              <a:gd name="connsiteX0" fmla="*/ 0 w 1222635"/>
              <a:gd name="connsiteY0" fmla="*/ 1545771 h 3124087"/>
              <a:gd name="connsiteX1" fmla="*/ 1222635 w 1222635"/>
              <a:gd name="connsiteY1" fmla="*/ 0 h 3124087"/>
              <a:gd name="connsiteX2" fmla="*/ 1222635 w 1222635"/>
              <a:gd name="connsiteY2" fmla="*/ 3124087 h 3124087"/>
              <a:gd name="connsiteX3" fmla="*/ 5740 w 1222635"/>
              <a:gd name="connsiteY3" fmla="*/ 1721216 h 3124087"/>
              <a:gd name="connsiteX4" fmla="*/ 0 w 1222635"/>
              <a:gd name="connsiteY4" fmla="*/ 1545771 h 3124087"/>
              <a:gd name="connsiteX0" fmla="*/ 0 w 1222635"/>
              <a:gd name="connsiteY0" fmla="*/ 1545771 h 3124087"/>
              <a:gd name="connsiteX1" fmla="*/ 1222635 w 1222635"/>
              <a:gd name="connsiteY1" fmla="*/ 0 h 3124087"/>
              <a:gd name="connsiteX2" fmla="*/ 1222635 w 1222635"/>
              <a:gd name="connsiteY2" fmla="*/ 3124087 h 3124087"/>
              <a:gd name="connsiteX3" fmla="*/ 22366 w 1222635"/>
              <a:gd name="connsiteY3" fmla="*/ 1746154 h 3124087"/>
              <a:gd name="connsiteX4" fmla="*/ 0 w 1222635"/>
              <a:gd name="connsiteY4" fmla="*/ 1545771 h 3124087"/>
              <a:gd name="connsiteX0" fmla="*/ 3390 w 1226025"/>
              <a:gd name="connsiteY0" fmla="*/ 1545771 h 3124087"/>
              <a:gd name="connsiteX1" fmla="*/ 1226025 w 1226025"/>
              <a:gd name="connsiteY1" fmla="*/ 0 h 3124087"/>
              <a:gd name="connsiteX2" fmla="*/ 1226025 w 1226025"/>
              <a:gd name="connsiteY2" fmla="*/ 3124087 h 3124087"/>
              <a:gd name="connsiteX3" fmla="*/ 818 w 1226025"/>
              <a:gd name="connsiteY3" fmla="*/ 1746154 h 3124087"/>
              <a:gd name="connsiteX4" fmla="*/ 3390 w 1226025"/>
              <a:gd name="connsiteY4" fmla="*/ 1545771 h 3124087"/>
              <a:gd name="connsiteX0" fmla="*/ 0 w 1222635"/>
              <a:gd name="connsiteY0" fmla="*/ 1545771 h 3124087"/>
              <a:gd name="connsiteX1" fmla="*/ 1222635 w 1222635"/>
              <a:gd name="connsiteY1" fmla="*/ 0 h 3124087"/>
              <a:gd name="connsiteX2" fmla="*/ 1222635 w 1222635"/>
              <a:gd name="connsiteY2" fmla="*/ 3124087 h 3124087"/>
              <a:gd name="connsiteX3" fmla="*/ 14053 w 1222635"/>
              <a:gd name="connsiteY3" fmla="*/ 1804343 h 3124087"/>
              <a:gd name="connsiteX4" fmla="*/ 0 w 1222635"/>
              <a:gd name="connsiteY4" fmla="*/ 1545771 h 3124087"/>
              <a:gd name="connsiteX0" fmla="*/ 3391 w 1209401"/>
              <a:gd name="connsiteY0" fmla="*/ 1612273 h 3124087"/>
              <a:gd name="connsiteX1" fmla="*/ 1209401 w 1209401"/>
              <a:gd name="connsiteY1" fmla="*/ 0 h 3124087"/>
              <a:gd name="connsiteX2" fmla="*/ 1209401 w 1209401"/>
              <a:gd name="connsiteY2" fmla="*/ 3124087 h 3124087"/>
              <a:gd name="connsiteX3" fmla="*/ 819 w 1209401"/>
              <a:gd name="connsiteY3" fmla="*/ 1804343 h 3124087"/>
              <a:gd name="connsiteX4" fmla="*/ 3391 w 1209401"/>
              <a:gd name="connsiteY4" fmla="*/ 1612273 h 3124087"/>
              <a:gd name="connsiteX0" fmla="*/ 0 w 1230948"/>
              <a:gd name="connsiteY0" fmla="*/ 1637211 h 3124087"/>
              <a:gd name="connsiteX1" fmla="*/ 1230948 w 1230948"/>
              <a:gd name="connsiteY1" fmla="*/ 0 h 3124087"/>
              <a:gd name="connsiteX2" fmla="*/ 1230948 w 1230948"/>
              <a:gd name="connsiteY2" fmla="*/ 3124087 h 3124087"/>
              <a:gd name="connsiteX3" fmla="*/ 22366 w 1230948"/>
              <a:gd name="connsiteY3" fmla="*/ 1804343 h 3124087"/>
              <a:gd name="connsiteX4" fmla="*/ 0 w 1230948"/>
              <a:gd name="connsiteY4" fmla="*/ 1637211 h 3124087"/>
              <a:gd name="connsiteX0" fmla="*/ 0 w 1222636"/>
              <a:gd name="connsiteY0" fmla="*/ 1637211 h 3124087"/>
              <a:gd name="connsiteX1" fmla="*/ 1222636 w 1222636"/>
              <a:gd name="connsiteY1" fmla="*/ 0 h 3124087"/>
              <a:gd name="connsiteX2" fmla="*/ 1222636 w 1222636"/>
              <a:gd name="connsiteY2" fmla="*/ 3124087 h 3124087"/>
              <a:gd name="connsiteX3" fmla="*/ 14054 w 1222636"/>
              <a:gd name="connsiteY3" fmla="*/ 1804343 h 3124087"/>
              <a:gd name="connsiteX4" fmla="*/ 0 w 1222636"/>
              <a:gd name="connsiteY4" fmla="*/ 1637211 h 3124087"/>
              <a:gd name="connsiteX0" fmla="*/ 11367 w 1234003"/>
              <a:gd name="connsiteY0" fmla="*/ 1637211 h 3124087"/>
              <a:gd name="connsiteX1" fmla="*/ 1234003 w 1234003"/>
              <a:gd name="connsiteY1" fmla="*/ 0 h 3124087"/>
              <a:gd name="connsiteX2" fmla="*/ 1234003 w 1234003"/>
              <a:gd name="connsiteY2" fmla="*/ 3124087 h 3124087"/>
              <a:gd name="connsiteX3" fmla="*/ 482 w 1234003"/>
              <a:gd name="connsiteY3" fmla="*/ 1804343 h 3124087"/>
              <a:gd name="connsiteX4" fmla="*/ 11367 w 1234003"/>
              <a:gd name="connsiteY4" fmla="*/ 1637211 h 3124087"/>
              <a:gd name="connsiteX0" fmla="*/ 11367 w 1234003"/>
              <a:gd name="connsiteY0" fmla="*/ 1637211 h 3124087"/>
              <a:gd name="connsiteX1" fmla="*/ 1234003 w 1234003"/>
              <a:gd name="connsiteY1" fmla="*/ 0 h 3124087"/>
              <a:gd name="connsiteX2" fmla="*/ 1234003 w 1234003"/>
              <a:gd name="connsiteY2" fmla="*/ 3124087 h 3124087"/>
              <a:gd name="connsiteX3" fmla="*/ 482 w 1234003"/>
              <a:gd name="connsiteY3" fmla="*/ 1804343 h 3124087"/>
              <a:gd name="connsiteX4" fmla="*/ 11367 w 1234003"/>
              <a:gd name="connsiteY4" fmla="*/ 1637211 h 3124087"/>
              <a:gd name="connsiteX0" fmla="*/ 11367 w 1234003"/>
              <a:gd name="connsiteY0" fmla="*/ 1663336 h 3124087"/>
              <a:gd name="connsiteX1" fmla="*/ 1234003 w 1234003"/>
              <a:gd name="connsiteY1" fmla="*/ 0 h 3124087"/>
              <a:gd name="connsiteX2" fmla="*/ 1234003 w 1234003"/>
              <a:gd name="connsiteY2" fmla="*/ 3124087 h 3124087"/>
              <a:gd name="connsiteX3" fmla="*/ 482 w 1234003"/>
              <a:gd name="connsiteY3" fmla="*/ 1804343 h 3124087"/>
              <a:gd name="connsiteX4" fmla="*/ 11367 w 1234003"/>
              <a:gd name="connsiteY4" fmla="*/ 1663336 h 3124087"/>
              <a:gd name="connsiteX0" fmla="*/ 526 w 1223162"/>
              <a:gd name="connsiteY0" fmla="*/ 1663336 h 3124087"/>
              <a:gd name="connsiteX1" fmla="*/ 1223162 w 1223162"/>
              <a:gd name="connsiteY1" fmla="*/ 0 h 3124087"/>
              <a:gd name="connsiteX2" fmla="*/ 1223162 w 1223162"/>
              <a:gd name="connsiteY2" fmla="*/ 3124087 h 3124087"/>
              <a:gd name="connsiteX3" fmla="*/ 1122 w 1223162"/>
              <a:gd name="connsiteY3" fmla="*/ 1810606 h 3124087"/>
              <a:gd name="connsiteX4" fmla="*/ 526 w 1223162"/>
              <a:gd name="connsiteY4" fmla="*/ 1663336 h 3124087"/>
              <a:gd name="connsiteX0" fmla="*/ 526 w 1223162"/>
              <a:gd name="connsiteY0" fmla="*/ 1669599 h 3124087"/>
              <a:gd name="connsiteX1" fmla="*/ 1223162 w 1223162"/>
              <a:gd name="connsiteY1" fmla="*/ 0 h 3124087"/>
              <a:gd name="connsiteX2" fmla="*/ 1223162 w 1223162"/>
              <a:gd name="connsiteY2" fmla="*/ 3124087 h 3124087"/>
              <a:gd name="connsiteX3" fmla="*/ 1122 w 1223162"/>
              <a:gd name="connsiteY3" fmla="*/ 1810606 h 3124087"/>
              <a:gd name="connsiteX4" fmla="*/ 526 w 1223162"/>
              <a:gd name="connsiteY4" fmla="*/ 1669599 h 312408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1223162" h="3124087">
                <a:moveTo>
                  <a:pt x="526" y="1669599"/>
                </a:moveTo>
                <a:lnTo>
                  <a:pt x="1223162" y="0"/>
                </a:lnTo>
                <a:lnTo>
                  <a:pt x="1223162" y="3124087"/>
                </a:lnTo>
                <a:lnTo>
                  <a:pt x="1122" y="1810606"/>
                </a:lnTo>
                <a:cubicBezTo>
                  <a:pt x="-2507" y="1284501"/>
                  <a:pt x="4155" y="2195704"/>
                  <a:pt x="526" y="1669599"/>
                </a:cubicBezTo>
                <a:close/>
              </a:path>
            </a:pathLst>
          </a:cu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B290BA7F-9B98-1126-4FB9-61444AA642F3}"/>
              </a:ext>
            </a:extLst>
          </p:cNvPr>
          <p:cNvSpPr txBox="1"/>
          <p:nvPr/>
        </p:nvSpPr>
        <p:spPr>
          <a:xfrm>
            <a:off x="308640" y="175538"/>
            <a:ext cx="129715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ja-JP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S4</a:t>
            </a:r>
            <a:endParaRPr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7E0445AD-AE23-0248-921A-BB92E007DD82}"/>
              </a:ext>
            </a:extLst>
          </p:cNvPr>
          <p:cNvSpPr txBox="1"/>
          <p:nvPr/>
        </p:nvSpPr>
        <p:spPr>
          <a:xfrm>
            <a:off x="3552371" y="848386"/>
            <a:ext cx="190212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VCAN</a:t>
            </a:r>
            <a:r>
              <a:rPr kumimoji="1" lang="en-US" altLang="ja-JP" sz="2000" b="1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High</a:t>
            </a:r>
            <a:r>
              <a:rPr kumimoji="1"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 area</a:t>
            </a:r>
            <a:endParaRPr kumimoji="1" lang="ja-JP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22480C3B-F620-D359-054C-1DBEF788CDE2}"/>
              </a:ext>
            </a:extLst>
          </p:cNvPr>
          <p:cNvSpPr txBox="1"/>
          <p:nvPr/>
        </p:nvSpPr>
        <p:spPr>
          <a:xfrm>
            <a:off x="13748258" y="848386"/>
            <a:ext cx="194957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VCAN</a:t>
            </a:r>
            <a:r>
              <a:rPr kumimoji="1" lang="en-US" altLang="ja-JP" sz="2000" b="1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Low</a:t>
            </a:r>
            <a:r>
              <a:rPr kumimoji="1" lang="en-US" altLang="ja-JP" sz="2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 area</a:t>
            </a:r>
            <a:endParaRPr kumimoji="1" lang="ja-JP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60A25ACA-541C-4B32-BFA9-5D0AD784653C}"/>
              </a:ext>
            </a:extLst>
          </p:cNvPr>
          <p:cNvSpPr txBox="1"/>
          <p:nvPr/>
        </p:nvSpPr>
        <p:spPr>
          <a:xfrm>
            <a:off x="7684647" y="4229133"/>
            <a:ext cx="98777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TIM-3</a:t>
            </a:r>
            <a:endParaRPr kumimoji="1" lang="ja-JP" altLang="en-US" sz="24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06E269F9-5FED-19A4-9386-73AA5763D908}"/>
              </a:ext>
            </a:extLst>
          </p:cNvPr>
          <p:cNvSpPr txBox="1"/>
          <p:nvPr/>
        </p:nvSpPr>
        <p:spPr>
          <a:xfrm>
            <a:off x="579715" y="7476358"/>
            <a:ext cx="5533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/>
              <a:t>50µm</a:t>
            </a:r>
            <a:endParaRPr kumimoji="1" lang="ja-JP" altLang="en-US" sz="1200" b="1" dirty="0"/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0016C9D3-092B-C9BC-CEB5-952387066BBA}"/>
              </a:ext>
            </a:extLst>
          </p:cNvPr>
          <p:cNvSpPr txBox="1"/>
          <p:nvPr/>
        </p:nvSpPr>
        <p:spPr>
          <a:xfrm>
            <a:off x="5900468" y="3547872"/>
            <a:ext cx="63350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/>
              <a:t>2.5mm</a:t>
            </a:r>
            <a:endParaRPr kumimoji="1" lang="ja-JP" altLang="en-US" sz="1200" b="1" dirty="0"/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1DB52559-DA1E-EF86-AEAE-13D5D73A1F4D}"/>
              </a:ext>
            </a:extLst>
          </p:cNvPr>
          <p:cNvSpPr txBox="1"/>
          <p:nvPr/>
        </p:nvSpPr>
        <p:spPr>
          <a:xfrm>
            <a:off x="579715" y="3547872"/>
            <a:ext cx="5533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/>
              <a:t>50µm</a:t>
            </a:r>
            <a:endParaRPr kumimoji="1" lang="ja-JP" altLang="en-US" sz="1200" b="1" dirty="0"/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0E07D45F-31B5-6DE2-4879-C8927B4CF9E5}"/>
              </a:ext>
            </a:extLst>
          </p:cNvPr>
          <p:cNvSpPr txBox="1"/>
          <p:nvPr/>
        </p:nvSpPr>
        <p:spPr>
          <a:xfrm>
            <a:off x="10818877" y="7476358"/>
            <a:ext cx="5533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/>
              <a:t>50µm</a:t>
            </a:r>
            <a:endParaRPr kumimoji="1" lang="ja-JP" altLang="en-US" sz="1200" b="1" dirty="0"/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7C1551FD-5B86-7623-B8DB-7303E6D5C0AA}"/>
              </a:ext>
            </a:extLst>
          </p:cNvPr>
          <p:cNvSpPr txBox="1"/>
          <p:nvPr/>
        </p:nvSpPr>
        <p:spPr>
          <a:xfrm>
            <a:off x="10818877" y="3547872"/>
            <a:ext cx="5533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/>
              <a:t>50µm</a:t>
            </a:r>
            <a:endParaRPr kumimoji="1" lang="ja-JP" altLang="en-US" sz="1200" b="1" dirty="0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DEF73A2C-624A-11B0-6F35-55C03F63D6F2}"/>
              </a:ext>
            </a:extLst>
          </p:cNvPr>
          <p:cNvSpPr txBox="1"/>
          <p:nvPr/>
        </p:nvSpPr>
        <p:spPr>
          <a:xfrm>
            <a:off x="5900467" y="7476358"/>
            <a:ext cx="63350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/>
              <a:t>2.5mm</a:t>
            </a:r>
            <a:endParaRPr kumimoji="1" lang="ja-JP" altLang="en-US" sz="1200" b="1" dirty="0"/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1D8D96C7-322F-2F59-0BF3-50DFB75B8656}"/>
              </a:ext>
            </a:extLst>
          </p:cNvPr>
          <p:cNvSpPr txBox="1"/>
          <p:nvPr/>
        </p:nvSpPr>
        <p:spPr>
          <a:xfrm>
            <a:off x="417163" y="8269855"/>
            <a:ext cx="15522747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4.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Heterogenous VCAN and TIM-3 staining. Using tumors with heterogenous VCAN staining pattern (n=24), stromal areas of each tumor were divided into those with strong VCAN staining (</a:t>
            </a:r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VCAN</a:t>
            </a:r>
            <a:r>
              <a:rPr lang="en-US" altLang="ja-JP" sz="1400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High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areas) and those with negative or moderate VCAN staining (</a:t>
            </a:r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VCAN</a:t>
            </a:r>
            <a:r>
              <a:rPr lang="en-US" altLang="ja-JP" sz="1400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Low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areas) (upper panels), and then TIM-3</a:t>
            </a:r>
            <a:r>
              <a:rPr lang="en-US" altLang="ja-JP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TIICs were evaluated in </a:t>
            </a:r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VCAN</a:t>
            </a:r>
            <a:r>
              <a:rPr lang="en-US" altLang="ja-JP" sz="1400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High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areas and </a:t>
            </a:r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VCAN</a:t>
            </a:r>
            <a:r>
              <a:rPr lang="en-US" altLang="ja-JP" sz="1400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Low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areas separately (lower panels).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DC342AAE-EC9C-9796-E267-97176FB0BFF8}"/>
              </a:ext>
            </a:extLst>
          </p:cNvPr>
          <p:cNvSpPr txBox="1"/>
          <p:nvPr/>
        </p:nvSpPr>
        <p:spPr>
          <a:xfrm>
            <a:off x="7585129" y="311570"/>
            <a:ext cx="118680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VCAN</a:t>
            </a:r>
            <a:endParaRPr kumimoji="1" lang="ja-JP" altLang="en-US" sz="24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" name="直線コネクタ 21">
            <a:extLst>
              <a:ext uri="{FF2B5EF4-FFF2-40B4-BE49-F238E27FC236}">
                <a16:creationId xmlns:a16="http://schemas.microsoft.com/office/drawing/2014/main" id="{59C36268-E37C-E7AB-12CC-AF86BEF1953E}"/>
              </a:ext>
            </a:extLst>
          </p:cNvPr>
          <p:cNvCxnSpPr>
            <a:cxnSpLocks/>
          </p:cNvCxnSpPr>
          <p:nvPr/>
        </p:nvCxnSpPr>
        <p:spPr>
          <a:xfrm>
            <a:off x="756356" y="732438"/>
            <a:ext cx="1472071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線コネクタ 23">
            <a:extLst>
              <a:ext uri="{FF2B5EF4-FFF2-40B4-BE49-F238E27FC236}">
                <a16:creationId xmlns:a16="http://schemas.microsoft.com/office/drawing/2014/main" id="{70C40C75-D887-7C46-49F6-F4281BA5A258}"/>
              </a:ext>
            </a:extLst>
          </p:cNvPr>
          <p:cNvCxnSpPr>
            <a:cxnSpLocks/>
          </p:cNvCxnSpPr>
          <p:nvPr/>
        </p:nvCxnSpPr>
        <p:spPr>
          <a:xfrm>
            <a:off x="756356" y="4645325"/>
            <a:ext cx="1472071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71230241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B4D3343C-31B9-7160-8843-1F821D4D9969}"/>
              </a:ext>
            </a:extLst>
          </p:cNvPr>
          <p:cNvSpPr txBox="1"/>
          <p:nvPr/>
        </p:nvSpPr>
        <p:spPr>
          <a:xfrm>
            <a:off x="4253186" y="1009476"/>
            <a:ext cx="3135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96A35DFB-CEC4-08A6-19E7-0AA2AAC89A0A}"/>
              </a:ext>
            </a:extLst>
          </p:cNvPr>
          <p:cNvSpPr txBox="1"/>
          <p:nvPr/>
        </p:nvSpPr>
        <p:spPr>
          <a:xfrm>
            <a:off x="5423479" y="3519700"/>
            <a:ext cx="82105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CD163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" name="直線矢印コネクタ 3">
            <a:extLst>
              <a:ext uri="{FF2B5EF4-FFF2-40B4-BE49-F238E27FC236}">
                <a16:creationId xmlns:a16="http://schemas.microsoft.com/office/drawing/2014/main" id="{6CC7BCC3-A8F2-CE0D-8D08-37D62A79FCA8}"/>
              </a:ext>
            </a:extLst>
          </p:cNvPr>
          <p:cNvCxnSpPr>
            <a:cxnSpLocks/>
          </p:cNvCxnSpPr>
          <p:nvPr/>
        </p:nvCxnSpPr>
        <p:spPr>
          <a:xfrm>
            <a:off x="5086284" y="3530213"/>
            <a:ext cx="158116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直線矢印コネクタ 4">
            <a:extLst>
              <a:ext uri="{FF2B5EF4-FFF2-40B4-BE49-F238E27FC236}">
                <a16:creationId xmlns:a16="http://schemas.microsoft.com/office/drawing/2014/main" id="{31714C5F-7293-6FC0-A673-E4BC024B8DFA}"/>
              </a:ext>
            </a:extLst>
          </p:cNvPr>
          <p:cNvCxnSpPr>
            <a:cxnSpLocks/>
          </p:cNvCxnSpPr>
          <p:nvPr/>
        </p:nvCxnSpPr>
        <p:spPr>
          <a:xfrm flipV="1">
            <a:off x="4697862" y="1528063"/>
            <a:ext cx="0" cy="153440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7FA711B0-E7BB-53E3-1B76-65E65577E02A}"/>
              </a:ext>
            </a:extLst>
          </p:cNvPr>
          <p:cNvSpPr txBox="1"/>
          <p:nvPr/>
        </p:nvSpPr>
        <p:spPr>
          <a:xfrm rot="16200000">
            <a:off x="4096365" y="2219594"/>
            <a:ext cx="85487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counts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図 6">
            <a:extLst>
              <a:ext uri="{FF2B5EF4-FFF2-40B4-BE49-F238E27FC236}">
                <a16:creationId xmlns:a16="http://schemas.microsoft.com/office/drawing/2014/main" id="{3DCB0A9D-B49F-5DBC-3768-D4A7BD1A7FE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4862" r="50000" b="4418"/>
          <a:stretch/>
        </p:blipFill>
        <p:spPr>
          <a:xfrm>
            <a:off x="4724113" y="1317253"/>
            <a:ext cx="2119734" cy="2161970"/>
          </a:xfrm>
          <a:prstGeom prst="rect">
            <a:avLst/>
          </a:prstGeom>
        </p:spPr>
      </p:pic>
      <p:graphicFrame>
        <p:nvGraphicFramePr>
          <p:cNvPr id="8" name="オブジェクト 7">
            <a:extLst>
              <a:ext uri="{FF2B5EF4-FFF2-40B4-BE49-F238E27FC236}">
                <a16:creationId xmlns:a16="http://schemas.microsoft.com/office/drawing/2014/main" id="{B1C05F46-2C0E-B6E7-BCFB-AC62DE8F863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99754102"/>
              </p:ext>
            </p:extLst>
          </p:nvPr>
        </p:nvGraphicFramePr>
        <p:xfrm>
          <a:off x="3976688" y="3886200"/>
          <a:ext cx="7851775" cy="35083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3" imgW="5374477" imgH="2398424" progId="Prism9.Document">
                  <p:embed/>
                </p:oleObj>
              </mc:Choice>
              <mc:Fallback>
                <p:oleObj name="Prism 9" r:id="rId3" imgW="5374477" imgH="2398424" progId="Prism9.Document">
                  <p:embed/>
                  <p:pic>
                    <p:nvPicPr>
                      <p:cNvPr id="26" name="オブジェクト 25">
                        <a:extLst>
                          <a:ext uri="{FF2B5EF4-FFF2-40B4-BE49-F238E27FC236}">
                            <a16:creationId xmlns:a16="http://schemas.microsoft.com/office/drawing/2014/main" id="{72BDEA3F-951D-CEDF-27F2-72FF5FB26F2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976688" y="3886200"/>
                        <a:ext cx="7851775" cy="35083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7936B3EF-56DA-4ECB-7F9A-4C40526ED1BC}"/>
              </a:ext>
            </a:extLst>
          </p:cNvPr>
          <p:cNvSpPr txBox="1"/>
          <p:nvPr/>
        </p:nvSpPr>
        <p:spPr>
          <a:xfrm>
            <a:off x="1614523" y="7549748"/>
            <a:ext cx="13258945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5. 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Generation of M2 and M1 macrophages. </a:t>
            </a:r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, Representative histograms for CD163 on in vitro-generated M0 (dark grey) and M2 macrophages (orange). </a:t>
            </a:r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, The expression levels of CD163 on M2 macrophages present as the mean ± </a:t>
            </a:r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s.e.m.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relative to those of M0 macrophages (n = 4). Mann–Whitney </a:t>
            </a:r>
            <a:r>
              <a:rPr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U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test. * </a:t>
            </a:r>
            <a:r>
              <a:rPr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&lt; 0.05. </a:t>
            </a:r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, Representative histograms for CD86 on in vitro-generated M0 (dark grey) and M1 macrophages (pink). </a:t>
            </a:r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, The expression levels of CD86 on M1 macrophages relative to those of M0 macrophages (n = 1). 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9BD6510E-94F6-447F-AD65-A9C8BFE7C7BF}"/>
              </a:ext>
            </a:extLst>
          </p:cNvPr>
          <p:cNvSpPr txBox="1"/>
          <p:nvPr/>
        </p:nvSpPr>
        <p:spPr>
          <a:xfrm>
            <a:off x="305613" y="224487"/>
            <a:ext cx="129715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ja-JP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S5</a:t>
            </a:r>
            <a:endParaRPr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23998C21-FFB8-8F2F-2B9D-68F9494C68ED}"/>
              </a:ext>
            </a:extLst>
          </p:cNvPr>
          <p:cNvSpPr txBox="1"/>
          <p:nvPr/>
        </p:nvSpPr>
        <p:spPr>
          <a:xfrm>
            <a:off x="4253186" y="4174930"/>
            <a:ext cx="3135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D9706F6D-77AB-BA12-9437-BF5B402993D8}"/>
              </a:ext>
            </a:extLst>
          </p:cNvPr>
          <p:cNvSpPr txBox="1"/>
          <p:nvPr/>
        </p:nvSpPr>
        <p:spPr>
          <a:xfrm>
            <a:off x="8235657" y="4174930"/>
            <a:ext cx="3135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図 13">
            <a:extLst>
              <a:ext uri="{FF2B5EF4-FFF2-40B4-BE49-F238E27FC236}">
                <a16:creationId xmlns:a16="http://schemas.microsoft.com/office/drawing/2014/main" id="{DDE7054B-F9E8-8AD2-3887-643CDFF5DA78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5375" r="46922" b="5473"/>
          <a:stretch/>
        </p:blipFill>
        <p:spPr>
          <a:xfrm>
            <a:off x="8811843" y="1317253"/>
            <a:ext cx="2092141" cy="2133828"/>
          </a:xfrm>
          <a:prstGeom prst="rect">
            <a:avLst/>
          </a:prstGeom>
        </p:spPr>
      </p:pic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3046B4FE-9E7F-8649-2F6D-BFA0FCDB644F}"/>
              </a:ext>
            </a:extLst>
          </p:cNvPr>
          <p:cNvSpPr txBox="1"/>
          <p:nvPr/>
        </p:nvSpPr>
        <p:spPr>
          <a:xfrm>
            <a:off x="9524894" y="3519700"/>
            <a:ext cx="70724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CD86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" name="直線矢印コネクタ 19">
            <a:extLst>
              <a:ext uri="{FF2B5EF4-FFF2-40B4-BE49-F238E27FC236}">
                <a16:creationId xmlns:a16="http://schemas.microsoft.com/office/drawing/2014/main" id="{44DAD1EE-AC50-51CF-4B83-4D42018B2B64}"/>
              </a:ext>
            </a:extLst>
          </p:cNvPr>
          <p:cNvCxnSpPr>
            <a:cxnSpLocks/>
          </p:cNvCxnSpPr>
          <p:nvPr/>
        </p:nvCxnSpPr>
        <p:spPr>
          <a:xfrm>
            <a:off x="9130792" y="3530213"/>
            <a:ext cx="158116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線矢印コネクタ 20">
            <a:extLst>
              <a:ext uri="{FF2B5EF4-FFF2-40B4-BE49-F238E27FC236}">
                <a16:creationId xmlns:a16="http://schemas.microsoft.com/office/drawing/2014/main" id="{74D48F7F-9733-8703-64DA-18F7F5F30C18}"/>
              </a:ext>
            </a:extLst>
          </p:cNvPr>
          <p:cNvCxnSpPr>
            <a:cxnSpLocks/>
          </p:cNvCxnSpPr>
          <p:nvPr/>
        </p:nvCxnSpPr>
        <p:spPr>
          <a:xfrm flipV="1">
            <a:off x="8742370" y="1528063"/>
            <a:ext cx="0" cy="153440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3D00CF0F-365C-2A00-F309-173E17D555D2}"/>
              </a:ext>
            </a:extLst>
          </p:cNvPr>
          <p:cNvSpPr txBox="1"/>
          <p:nvPr/>
        </p:nvSpPr>
        <p:spPr>
          <a:xfrm rot="16200000">
            <a:off x="8140873" y="2219594"/>
            <a:ext cx="85487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counts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5" name="グループ化 14">
            <a:extLst>
              <a:ext uri="{FF2B5EF4-FFF2-40B4-BE49-F238E27FC236}">
                <a16:creationId xmlns:a16="http://schemas.microsoft.com/office/drawing/2014/main" id="{FA725AE1-FC98-EBD0-F632-3ACF57702A82}"/>
              </a:ext>
            </a:extLst>
          </p:cNvPr>
          <p:cNvGrpSpPr/>
          <p:nvPr/>
        </p:nvGrpSpPr>
        <p:grpSpPr>
          <a:xfrm>
            <a:off x="10988121" y="1453875"/>
            <a:ext cx="781072" cy="697627"/>
            <a:chOff x="3184742" y="1609738"/>
            <a:chExt cx="781072" cy="697627"/>
          </a:xfrm>
        </p:grpSpPr>
        <p:sp>
          <p:nvSpPr>
            <p:cNvPr id="16" name="正方形/長方形 15">
              <a:extLst>
                <a:ext uri="{FF2B5EF4-FFF2-40B4-BE49-F238E27FC236}">
                  <a16:creationId xmlns:a16="http://schemas.microsoft.com/office/drawing/2014/main" id="{3FE6701B-28EC-ABE1-C045-8BDBEAE6799C}"/>
                </a:ext>
              </a:extLst>
            </p:cNvPr>
            <p:cNvSpPr/>
            <p:nvPr/>
          </p:nvSpPr>
          <p:spPr>
            <a:xfrm>
              <a:off x="3184742" y="1683459"/>
              <a:ext cx="100873" cy="100873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  <a:ln>
              <a:solidFill>
                <a:schemeClr val="bg2">
                  <a:lumMod val="9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/>
            </a:p>
          </p:txBody>
        </p:sp>
        <p:sp>
          <p:nvSpPr>
            <p:cNvPr id="17" name="正方形/長方形 16">
              <a:extLst>
                <a:ext uri="{FF2B5EF4-FFF2-40B4-BE49-F238E27FC236}">
                  <a16:creationId xmlns:a16="http://schemas.microsoft.com/office/drawing/2014/main" id="{A1FA006A-BE93-CDB5-6FAD-D96876E83B75}"/>
                </a:ext>
              </a:extLst>
            </p:cNvPr>
            <p:cNvSpPr/>
            <p:nvPr/>
          </p:nvSpPr>
          <p:spPr>
            <a:xfrm>
              <a:off x="3184742" y="1909241"/>
              <a:ext cx="100873" cy="100873"/>
            </a:xfrm>
            <a:prstGeom prst="rect">
              <a:avLst/>
            </a:prstGeom>
            <a:solidFill>
              <a:schemeClr val="bg2">
                <a:lumMod val="75000"/>
              </a:schemeClr>
            </a:solidFill>
            <a:ln>
              <a:solidFill>
                <a:schemeClr val="bg2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/>
            </a:p>
          </p:txBody>
        </p:sp>
        <p:sp>
          <p:nvSpPr>
            <p:cNvPr id="18" name="正方形/長方形 17">
              <a:extLst>
                <a:ext uri="{FF2B5EF4-FFF2-40B4-BE49-F238E27FC236}">
                  <a16:creationId xmlns:a16="http://schemas.microsoft.com/office/drawing/2014/main" id="{CD86DAC6-96B9-D216-A46C-C2B88F77702D}"/>
                </a:ext>
              </a:extLst>
            </p:cNvPr>
            <p:cNvSpPr/>
            <p:nvPr/>
          </p:nvSpPr>
          <p:spPr>
            <a:xfrm>
              <a:off x="3184742" y="2112719"/>
              <a:ext cx="100873" cy="100873"/>
            </a:xfrm>
            <a:prstGeom prst="rect">
              <a:avLst/>
            </a:prstGeom>
            <a:solidFill>
              <a:srgbClr val="FF0000">
                <a:alpha val="25000"/>
              </a:srgbClr>
            </a:solidFill>
            <a:ln>
              <a:solidFill>
                <a:srgbClr val="FF0000">
                  <a:alpha val="29000"/>
                </a:srgb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/>
            </a:p>
          </p:txBody>
        </p:sp>
        <p:sp>
          <p:nvSpPr>
            <p:cNvPr id="23" name="テキスト ボックス 22">
              <a:extLst>
                <a:ext uri="{FF2B5EF4-FFF2-40B4-BE49-F238E27FC236}">
                  <a16:creationId xmlns:a16="http://schemas.microsoft.com/office/drawing/2014/main" id="{A6014F10-4B86-3002-96D7-985E3108CA8E}"/>
                </a:ext>
              </a:extLst>
            </p:cNvPr>
            <p:cNvSpPr txBox="1"/>
            <p:nvPr/>
          </p:nvSpPr>
          <p:spPr>
            <a:xfrm>
              <a:off x="3285820" y="1609738"/>
              <a:ext cx="679994" cy="69762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spcAft>
                  <a:spcPts val="200"/>
                </a:spcAft>
              </a:pPr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Isotype</a:t>
              </a:r>
            </a:p>
            <a:p>
              <a:pPr>
                <a:spcAft>
                  <a:spcPts val="200"/>
                </a:spcAft>
              </a:pPr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M0</a:t>
              </a:r>
            </a:p>
            <a:p>
              <a:pPr>
                <a:spcAft>
                  <a:spcPts val="200"/>
                </a:spcAft>
              </a:pPr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M1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4" name="グループ化 23">
            <a:extLst>
              <a:ext uri="{FF2B5EF4-FFF2-40B4-BE49-F238E27FC236}">
                <a16:creationId xmlns:a16="http://schemas.microsoft.com/office/drawing/2014/main" id="{181558AB-78ED-A5A7-41FE-80A42380CFFD}"/>
              </a:ext>
            </a:extLst>
          </p:cNvPr>
          <p:cNvGrpSpPr/>
          <p:nvPr/>
        </p:nvGrpSpPr>
        <p:grpSpPr>
          <a:xfrm>
            <a:off x="6898625" y="1459860"/>
            <a:ext cx="769497" cy="697627"/>
            <a:chOff x="3184742" y="1609738"/>
            <a:chExt cx="769497" cy="697627"/>
          </a:xfrm>
        </p:grpSpPr>
        <p:sp>
          <p:nvSpPr>
            <p:cNvPr id="25" name="正方形/長方形 24">
              <a:extLst>
                <a:ext uri="{FF2B5EF4-FFF2-40B4-BE49-F238E27FC236}">
                  <a16:creationId xmlns:a16="http://schemas.microsoft.com/office/drawing/2014/main" id="{BDA27514-C88B-AFE5-E363-0E5B29191AB1}"/>
                </a:ext>
              </a:extLst>
            </p:cNvPr>
            <p:cNvSpPr/>
            <p:nvPr/>
          </p:nvSpPr>
          <p:spPr>
            <a:xfrm>
              <a:off x="3184742" y="1683459"/>
              <a:ext cx="100873" cy="100873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  <a:ln>
              <a:solidFill>
                <a:schemeClr val="bg2">
                  <a:lumMod val="9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/>
            </a:p>
          </p:txBody>
        </p:sp>
        <p:sp>
          <p:nvSpPr>
            <p:cNvPr id="26" name="正方形/長方形 25">
              <a:extLst>
                <a:ext uri="{FF2B5EF4-FFF2-40B4-BE49-F238E27FC236}">
                  <a16:creationId xmlns:a16="http://schemas.microsoft.com/office/drawing/2014/main" id="{9BF94D4C-6F51-1813-C2D8-98270921EE2C}"/>
                </a:ext>
              </a:extLst>
            </p:cNvPr>
            <p:cNvSpPr/>
            <p:nvPr/>
          </p:nvSpPr>
          <p:spPr>
            <a:xfrm>
              <a:off x="3184742" y="1900598"/>
              <a:ext cx="100873" cy="100873"/>
            </a:xfrm>
            <a:prstGeom prst="rect">
              <a:avLst/>
            </a:prstGeom>
            <a:solidFill>
              <a:schemeClr val="bg2">
                <a:lumMod val="75000"/>
              </a:schemeClr>
            </a:solidFill>
            <a:ln>
              <a:solidFill>
                <a:schemeClr val="bg2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/>
            </a:p>
          </p:txBody>
        </p:sp>
        <p:sp>
          <p:nvSpPr>
            <p:cNvPr id="27" name="正方形/長方形 26">
              <a:extLst>
                <a:ext uri="{FF2B5EF4-FFF2-40B4-BE49-F238E27FC236}">
                  <a16:creationId xmlns:a16="http://schemas.microsoft.com/office/drawing/2014/main" id="{8C23F4E7-A2C2-59A0-552B-948BBA92CAB6}"/>
                </a:ext>
              </a:extLst>
            </p:cNvPr>
            <p:cNvSpPr/>
            <p:nvPr/>
          </p:nvSpPr>
          <p:spPr>
            <a:xfrm>
              <a:off x="3184742" y="2113001"/>
              <a:ext cx="100873" cy="100873"/>
            </a:xfrm>
            <a:prstGeom prst="rect">
              <a:avLst/>
            </a:prstGeom>
            <a:solidFill>
              <a:schemeClr val="accent2">
                <a:lumMod val="40000"/>
                <a:lumOff val="60000"/>
              </a:schemeClr>
            </a:solidFill>
            <a:ln>
              <a:solidFill>
                <a:schemeClr val="accent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/>
            </a:p>
          </p:txBody>
        </p:sp>
        <p:sp>
          <p:nvSpPr>
            <p:cNvPr id="28" name="テキスト ボックス 27">
              <a:extLst>
                <a:ext uri="{FF2B5EF4-FFF2-40B4-BE49-F238E27FC236}">
                  <a16:creationId xmlns:a16="http://schemas.microsoft.com/office/drawing/2014/main" id="{F52A5D43-8B1C-CECE-B9BB-749A1894546F}"/>
                </a:ext>
              </a:extLst>
            </p:cNvPr>
            <p:cNvSpPr txBox="1"/>
            <p:nvPr/>
          </p:nvSpPr>
          <p:spPr>
            <a:xfrm>
              <a:off x="3274245" y="1609738"/>
              <a:ext cx="679994" cy="69762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spcAft>
                  <a:spcPts val="200"/>
                </a:spcAft>
              </a:pPr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Isotype</a:t>
              </a:r>
            </a:p>
            <a:p>
              <a:pPr>
                <a:spcAft>
                  <a:spcPts val="200"/>
                </a:spcAft>
              </a:pPr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M0</a:t>
              </a:r>
            </a:p>
            <a:p>
              <a:pPr>
                <a:spcAft>
                  <a:spcPts val="200"/>
                </a:spcAft>
              </a:pPr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M2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D441656A-7A5A-DB5B-B135-FBEFABCA25E6}"/>
              </a:ext>
            </a:extLst>
          </p:cNvPr>
          <p:cNvSpPr txBox="1"/>
          <p:nvPr/>
        </p:nvSpPr>
        <p:spPr>
          <a:xfrm>
            <a:off x="8235657" y="1009476"/>
            <a:ext cx="3135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8398966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" name="図 27">
            <a:extLst>
              <a:ext uri="{FF2B5EF4-FFF2-40B4-BE49-F238E27FC236}">
                <a16:creationId xmlns:a16="http://schemas.microsoft.com/office/drawing/2014/main" id="{7EB2471A-092D-FB30-D9AA-C0D28AE662F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68976" y="745653"/>
            <a:ext cx="14187211" cy="3035359"/>
          </a:xfrm>
          <a:prstGeom prst="rect">
            <a:avLst/>
          </a:prstGeom>
        </p:spPr>
      </p:pic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6F4668BF-9524-04B9-7600-FDAA976738CA}"/>
              </a:ext>
            </a:extLst>
          </p:cNvPr>
          <p:cNvSpPr txBox="1"/>
          <p:nvPr/>
        </p:nvSpPr>
        <p:spPr>
          <a:xfrm>
            <a:off x="305613" y="224487"/>
            <a:ext cx="129715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ja-JP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S6</a:t>
            </a:r>
            <a:endParaRPr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" name="オブジェクト 2">
            <a:extLst>
              <a:ext uri="{FF2B5EF4-FFF2-40B4-BE49-F238E27FC236}">
                <a16:creationId xmlns:a16="http://schemas.microsoft.com/office/drawing/2014/main" id="{F4D21235-51B2-737C-EF6B-C5C9D1FC3B9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82827216"/>
              </p:ext>
            </p:extLst>
          </p:nvPr>
        </p:nvGraphicFramePr>
        <p:xfrm>
          <a:off x="1047750" y="3795713"/>
          <a:ext cx="13893800" cy="44307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3" imgW="9260184" imgH="2948806" progId="Prism9.Document">
                  <p:embed/>
                </p:oleObj>
              </mc:Choice>
              <mc:Fallback>
                <p:oleObj name="Prism 9" r:id="rId3" imgW="9260184" imgH="2948806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047750" y="3795713"/>
                        <a:ext cx="13893800" cy="44307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C0E2C946-4CC7-02E4-634A-6846701056E4}"/>
              </a:ext>
            </a:extLst>
          </p:cNvPr>
          <p:cNvSpPr txBox="1"/>
          <p:nvPr/>
        </p:nvSpPr>
        <p:spPr>
          <a:xfrm>
            <a:off x="572205" y="718009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6B119687-CC41-F6C2-4B31-B54301764459}"/>
              </a:ext>
            </a:extLst>
          </p:cNvPr>
          <p:cNvSpPr txBox="1"/>
          <p:nvPr/>
        </p:nvSpPr>
        <p:spPr>
          <a:xfrm>
            <a:off x="1322268" y="394809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EB5DBC75-CD59-20B0-80DE-8039966C67C2}"/>
              </a:ext>
            </a:extLst>
          </p:cNvPr>
          <p:cNvSpPr txBox="1"/>
          <p:nvPr/>
        </p:nvSpPr>
        <p:spPr>
          <a:xfrm>
            <a:off x="4226716" y="3900218"/>
            <a:ext cx="325183" cy="3709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F5DB68D6-F686-8AB1-477E-3D88D38DF013}"/>
              </a:ext>
            </a:extLst>
          </p:cNvPr>
          <p:cNvSpPr txBox="1"/>
          <p:nvPr/>
        </p:nvSpPr>
        <p:spPr>
          <a:xfrm>
            <a:off x="7564825" y="3948902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23C547E0-5C8C-21DF-FB6E-66D2ED6FF461}"/>
              </a:ext>
            </a:extLst>
          </p:cNvPr>
          <p:cNvSpPr txBox="1"/>
          <p:nvPr/>
        </p:nvSpPr>
        <p:spPr>
          <a:xfrm>
            <a:off x="11327491" y="3947330"/>
            <a:ext cx="325183" cy="3709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2248C055-3E53-1DFF-0CA8-A3679B176F18}"/>
              </a:ext>
            </a:extLst>
          </p:cNvPr>
          <p:cNvSpPr txBox="1"/>
          <p:nvPr/>
        </p:nvSpPr>
        <p:spPr>
          <a:xfrm>
            <a:off x="305613" y="7965771"/>
            <a:ext cx="15664721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6.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CD14</a:t>
            </a:r>
            <a:r>
              <a:rPr lang="en-US" altLang="ja-JP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monocytes, CD3</a:t>
            </a:r>
            <a:r>
              <a:rPr lang="en-US" altLang="ja-JP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  <a:r>
              <a:rPr lang="en-US" altLang="ja-JP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T-cells and CD3</a:t>
            </a:r>
            <a:r>
              <a:rPr lang="en-US" altLang="ja-JP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CD8</a:t>
            </a:r>
            <a:r>
              <a:rPr lang="en-US" altLang="ja-JP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T-cells from PBMCs. </a:t>
            </a:r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A,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Gating strategy for flow cytometry of CD14</a:t>
            </a:r>
            <a:r>
              <a:rPr lang="en-US" altLang="ja-JP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monocytes, CD3</a:t>
            </a:r>
            <a:r>
              <a:rPr lang="en-US" altLang="ja-JP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  <a:r>
              <a:rPr lang="en-US" altLang="ja-JP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T-cells and CD3</a:t>
            </a:r>
            <a:r>
              <a:rPr lang="en-US" altLang="ja-JP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CD8</a:t>
            </a:r>
            <a:r>
              <a:rPr lang="en-US" altLang="ja-JP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T-cells from PBMCs. </a:t>
            </a:r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C,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TIM-3 expression on CD4</a:t>
            </a:r>
            <a:r>
              <a:rPr lang="en-US" altLang="ja-JP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T-cells (</a:t>
            </a:r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) and CD8</a:t>
            </a:r>
            <a:r>
              <a:rPr lang="en-US" altLang="ja-JP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T-cells (</a:t>
            </a:r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), treated with various concentrations of TGF</a:t>
            </a:r>
            <a:r>
              <a:rPr lang="el-GR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as indicated. TIM-3 levels on TGFβ-treated cells present as the mean ± </a:t>
            </a:r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s.e.m.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relative to those of controls (n = 4). Kruskal-Wallis test.  </a:t>
            </a:r>
            <a:r>
              <a:rPr lang="en-US" altLang="ja-JP" sz="1400" i="1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r>
              <a:rPr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&gt; 0.05. </a:t>
            </a:r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D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 E,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TIM-3 expression on IL-2-stimulated CD4</a:t>
            </a:r>
            <a:r>
              <a:rPr lang="en-US" altLang="ja-JP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T-cells (</a:t>
            </a:r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) and CD8</a:t>
            </a:r>
            <a:r>
              <a:rPr lang="en-US" altLang="ja-JP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T-cells (</a:t>
            </a:r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), treated with or without TGF</a:t>
            </a:r>
            <a:r>
              <a:rPr lang="el-GR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(10 ng/ml). TIM-3 levels on IL-2 and/or TGFβ-treated cells present as the mean ± s.e.m. relative to those of untreated cells (n = 5). Kruskal-Wallis test.  </a:t>
            </a:r>
            <a:r>
              <a:rPr lang="en-US" altLang="ja-JP" sz="1400" i="1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r>
              <a:rPr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&gt; 0.05. 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009193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4792</TotalTime>
  <Words>574</Words>
  <Application>Microsoft Office PowerPoint</Application>
  <PresentationFormat>ユーザー設定</PresentationFormat>
  <Paragraphs>50</Paragraphs>
  <Slides>6</Slides>
  <Notes>0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1</vt:i4>
      </vt:variant>
      <vt:variant>
        <vt:lpstr>スライド タイトル</vt:lpstr>
      </vt:variant>
      <vt:variant>
        <vt:i4>6</vt:i4>
      </vt:variant>
    </vt:vector>
  </HeadingPairs>
  <TitlesOfParts>
    <vt:vector size="11" baseType="lpstr">
      <vt:lpstr>Arial</vt:lpstr>
      <vt:lpstr>Calibri</vt:lpstr>
      <vt:lpstr>Calibri Light</vt:lpstr>
      <vt:lpstr>Office テーマ</vt:lpstr>
      <vt:lpstr>Prism 9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Okayama Hirokazu</dc:creator>
  <cp:lastModifiedBy>Hirokazu Okayama</cp:lastModifiedBy>
  <cp:revision>245</cp:revision>
  <dcterms:created xsi:type="dcterms:W3CDTF">2021-03-22T01:44:43Z</dcterms:created>
  <dcterms:modified xsi:type="dcterms:W3CDTF">2023-09-27T14:40:17Z</dcterms:modified>
</cp:coreProperties>
</file>